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1" r:id="rId2"/>
    <p:sldId id="264" r:id="rId3"/>
    <p:sldId id="262" r:id="rId4"/>
    <p:sldId id="266" r:id="rId5"/>
    <p:sldId id="267" r:id="rId6"/>
    <p:sldId id="268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ALANA CARPENTER" initials="AC" lastIdx="5" clrIdx="0">
    <p:extLst>
      <p:ext uri="{19B8F6BF-5375-455C-9EA6-DF929625EA0E}">
        <p15:presenceInfo xmlns:p15="http://schemas.microsoft.com/office/powerpoint/2012/main" userId="ALANA CARPENTER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99999"/>
    <a:srgbClr val="A6761C"/>
    <a:srgbClr val="EDB000"/>
    <a:srgbClr val="8DA0CB"/>
    <a:srgbClr val="984DA3"/>
    <a:srgbClr val="FFFF32"/>
    <a:srgbClr val="A65627"/>
    <a:srgbClr val="F881BF"/>
    <a:srgbClr val="4CAF4A"/>
    <a:srgbClr val="377EB8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809" autoAdjust="0"/>
    <p:restoredTop sz="96163" autoAdjust="0"/>
  </p:normalViewPr>
  <p:slideViewPr>
    <p:cSldViewPr snapToGrid="0">
      <p:cViewPr varScale="1">
        <p:scale>
          <a:sx n="113" d="100"/>
          <a:sy n="113" d="100"/>
        </p:scale>
        <p:origin x="75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C1389F8-692C-41F4-9DCC-CABB4577CE8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AAD937F8-B4CA-46BA-BC56-42F0DD97B7D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2F99A2D-C4AA-46E6-8B12-9A267129E3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A506F2D-CDEC-4BCC-88B3-6F935015CB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347071-3EA3-463F-816D-A1BD14F3C1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7244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AD26D22-85F1-4553-B870-742139C9E3E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296AA1E-29F6-4FBB-A0C9-3D59A7AA080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74AB45-EDFF-45EB-B287-D09F5AE43E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AE07DC-2D5F-490B-AFF7-B326FA37AAA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BAEA40A-23D4-485F-A0EF-E82AE52500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0476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1F57B31-9548-4328-AF4E-3D296F478CF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8A8BDDD-B079-4C51-898B-44A1D7E24E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5F47CE-89CF-4D2B-8504-2FE6BB95C0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928937-2F11-4C55-8C15-EDB51FF253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480FA7-E280-4FB2-A749-368E40C49B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97508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46CD51A-043B-4E5D-9C83-26ED40F91AD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77E2DD-6692-4B0D-B468-840C14E03BAC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EF26FE-FC25-4B13-BA97-2F825881F91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A9EC4D-CE00-4BAF-B10D-59D89E9AC2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BE2A6C1-874A-4C8C-9FC5-44120F98A00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34768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9640A43-8D60-4008-966D-6D607BD7828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F420C18-B28F-4B63-8636-EC33515A9D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68B0005-52B9-4120-9ACA-171C1A216C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88E0F11-7D6F-41DE-ABC5-C03053A767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30BCA5-F5F1-484F-90FE-6CCCCD99D8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19324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6BEBBC-DBBC-4E92-AEB2-297C0C2F48A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ABA5BF-30BA-4CE4-8B5A-E5F882DF369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E63256C-1CCC-4267-B589-00FB0493BC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51E173E-A65E-414B-9A15-8CE9474C59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C651FED-E2B7-457D-AFCF-3E4BDA4355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62A339D-8649-49E1-B449-21D7D630C0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274983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6FEBC48-6FFB-4C81-90BE-1EEA420A21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E05F499-1DB6-45B9-A563-FBB7ABBA507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853D25E-7646-43B6-851F-165B355C592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89A96BD-372D-4D70-BF6D-6A363FC42DD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0CF29B6-5ED3-4528-845A-A59E0A9196D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BD207F1-B9A1-4196-B592-E2CD418E6E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D684207-44D6-443E-9A69-9FC7FCF870E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08A2EFC-FA62-4997-AD72-453F293AC68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7702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9FB0E5-1ED0-424C-9962-8105F1020A2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9BC8073-15E1-4FA8-8247-B6A9296EB8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B5F1C8E-FA20-4E8F-B953-91A2930872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7AF5EEB-D400-4658-A7BF-DA9447578E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323023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48ED48F-9EB5-4682-A460-47C52A94EE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C2452A43-CBA9-4BA9-9FEF-1D1784DB7AD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2D687A-EF94-4B15-BF48-247C118CD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30826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46204-CBA9-4C5F-9C6D-5084037C1C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670B5F6-19F7-4E41-B178-257D865FB9A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AF247D1-1D30-467E-ADF0-096B78168C6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326E18F-29CA-468F-8701-F4EF7655FA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BCFFB37-2EEE-4727-B8BD-22F93E9EE9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3FC8AB2-557A-4EF1-B4DC-A85650DE0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46862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43D019-0132-4630-9127-F8C28BEA371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D17186-3B47-4738-AE20-106485EDAF6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251E56B-436B-4C0E-B0B8-44B29CB9456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F396DA1-131C-4B62-BFEE-2475B7AEA8C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2A37BAB-5077-489B-B47A-D8EA31D30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2822270-1E20-4FA7-9F7A-FC61CEC93B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89028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0568EB06-891C-4004-AFDB-49ECEF343F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6A787BA-F1BD-445D-A298-88724457001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4727F33-5101-4046-BD7F-36CE8D3C6C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9A50B51-A471-4F8E-97E9-B7C6AEA82468}" type="datetimeFigureOut">
              <a:rPr lang="en-US" smtClean="0"/>
              <a:t>12/21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56CC6B-02C3-491F-A299-9F9093637A89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4EFB95-031B-41F1-9E98-58CBE48E1C7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781EE51-3ECD-481C-BFE5-9083798F8AA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2284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2489A36-9C51-4070-ACA7-FC12F2369AF9}"/>
              </a:ext>
            </a:extLst>
          </p:cNvPr>
          <p:cNvSpPr txBox="1"/>
          <p:nvPr/>
        </p:nvSpPr>
        <p:spPr>
          <a:xfrm>
            <a:off x="1362268" y="6106483"/>
            <a:ext cx="8733453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1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ummary of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y metabolites that participate in various metabolic pathways whe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ng day 1 to the pre-irradiation timepoint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39" name="Group 38">
            <a:extLst>
              <a:ext uri="{FF2B5EF4-FFF2-40B4-BE49-F238E27FC236}">
                <a16:creationId xmlns:a16="http://schemas.microsoft.com/office/drawing/2014/main" id="{61315404-70E8-44AE-B622-DA1F71BF0FF5}"/>
              </a:ext>
            </a:extLst>
          </p:cNvPr>
          <p:cNvGrpSpPr/>
          <p:nvPr/>
        </p:nvGrpSpPr>
        <p:grpSpPr>
          <a:xfrm>
            <a:off x="2906098" y="506191"/>
            <a:ext cx="8739903" cy="5372100"/>
            <a:chOff x="2906098" y="506191"/>
            <a:chExt cx="8739903" cy="537210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6DBEE4C0-607C-42D2-9C01-36A8371B6A29}"/>
                </a:ext>
              </a:extLst>
            </p:cNvPr>
            <p:cNvGrpSpPr/>
            <p:nvPr/>
          </p:nvGrpSpPr>
          <p:grpSpPr>
            <a:xfrm>
              <a:off x="2906098" y="506191"/>
              <a:ext cx="5704502" cy="5372100"/>
              <a:chOff x="2906098" y="0"/>
              <a:chExt cx="5704502" cy="5372100"/>
            </a:xfrm>
          </p:grpSpPr>
          <p:pic>
            <p:nvPicPr>
              <p:cNvPr id="5" name="Picture 4">
                <a:extLst>
                  <a:ext uri="{FF2B5EF4-FFF2-40B4-BE49-F238E27FC236}">
                    <a16:creationId xmlns:a16="http://schemas.microsoft.com/office/drawing/2014/main" id="{1958F096-54DD-4403-AED3-46068E6F6EC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985"/>
              <a:stretch/>
            </p:blipFill>
            <p:spPr>
              <a:xfrm>
                <a:off x="3581400" y="0"/>
                <a:ext cx="5029200" cy="5372100"/>
              </a:xfrm>
              <a:prstGeom prst="rect">
                <a:avLst/>
              </a:prstGeom>
            </p:spPr>
          </p:pic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5595BF24-FA62-4771-BAC8-AD621D0E6B34}"/>
                  </a:ext>
                </a:extLst>
              </p:cNvPr>
              <p:cNvSpPr txBox="1"/>
              <p:nvPr/>
            </p:nvSpPr>
            <p:spPr>
              <a:xfrm>
                <a:off x="4093609" y="228297"/>
                <a:ext cx="1878951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Glycero-3-phosphocholine</a:t>
                </a:r>
                <a:endParaRPr lang="en-US" sz="1200" dirty="0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73718594-177C-4329-B051-093E71DC9995}"/>
                  </a:ext>
                </a:extLst>
              </p:cNvPr>
              <p:cNvSpPr txBox="1"/>
              <p:nvPr/>
            </p:nvSpPr>
            <p:spPr>
              <a:xfrm>
                <a:off x="2990155" y="521806"/>
                <a:ext cx="216771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alpha-Hydroxypregnenolone</a:t>
                </a:r>
                <a:endParaRPr lang="en-US" sz="10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777E031C-7465-4FF9-9726-B21C3A22A279}"/>
                  </a:ext>
                </a:extLst>
              </p:cNvPr>
              <p:cNvSpPr txBox="1"/>
              <p:nvPr/>
            </p:nvSpPr>
            <p:spPr>
              <a:xfrm>
                <a:off x="3531249" y="933931"/>
                <a:ext cx="1085526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riacylglycerol</a:t>
                </a:r>
                <a:endParaRPr lang="en-US" sz="700" b="1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CDF0AE2A-A108-4FB1-82F3-17597E6740FA}"/>
                  </a:ext>
                </a:extLst>
              </p:cNvPr>
              <p:cNvSpPr txBox="1"/>
              <p:nvPr/>
            </p:nvSpPr>
            <p:spPr>
              <a:xfrm>
                <a:off x="3112502" y="1538347"/>
                <a:ext cx="1085527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C(20:2/18:0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BDC1116D-4642-422D-A494-7C6FFC500168}"/>
                  </a:ext>
                </a:extLst>
              </p:cNvPr>
              <p:cNvSpPr txBox="1"/>
              <p:nvPr/>
            </p:nvSpPr>
            <p:spPr>
              <a:xfrm>
                <a:off x="2911473" y="2232554"/>
                <a:ext cx="1085527" cy="2923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E(22:6/18:2)</a:t>
                </a:r>
              </a:p>
              <a:p>
                <a:endParaRPr lang="en-US" sz="100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C4AC3A35-F48D-4A2A-89FC-9D5DA0B8D3C5}"/>
                  </a:ext>
                </a:extLst>
              </p:cNvPr>
              <p:cNvSpPr txBox="1"/>
              <p:nvPr/>
            </p:nvSpPr>
            <p:spPr>
              <a:xfrm>
                <a:off x="2906098" y="2933860"/>
                <a:ext cx="109090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Menaquinone</a:t>
                </a:r>
                <a:endParaRPr lang="en-US" sz="100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AD9FDECB-668D-4780-8FD5-6EAA31607799}"/>
                  </a:ext>
                </a:extLst>
              </p:cNvPr>
              <p:cNvSpPr txBox="1"/>
              <p:nvPr/>
            </p:nvSpPr>
            <p:spPr>
              <a:xfrm>
                <a:off x="3281073" y="3694429"/>
                <a:ext cx="967077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-Galactose</a:t>
                </a:r>
                <a:endParaRPr lang="en-US" sz="100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8B70822-3113-4434-912E-958CD4AAA0E4}"/>
                  </a:ext>
                </a:extLst>
              </p:cNvPr>
              <p:cNvSpPr txBox="1"/>
              <p:nvPr/>
            </p:nvSpPr>
            <p:spPr>
              <a:xfrm>
                <a:off x="3558885" y="4308062"/>
                <a:ext cx="105789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Androsterone</a:t>
                </a:r>
                <a:endParaRPr lang="en-US" sz="100" b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5C2382BE-7C9E-4748-9F37-5FD19FAFF9D1}"/>
                  </a:ext>
                </a:extLst>
              </p:cNvPr>
              <p:cNvSpPr txBox="1"/>
              <p:nvPr/>
            </p:nvSpPr>
            <p:spPr>
              <a:xfrm>
                <a:off x="4186074" y="4644696"/>
                <a:ext cx="1005826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estosterone</a:t>
                </a:r>
                <a:endParaRPr lang="en-US" sz="100" b="1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6A7F68F9-FCEC-427B-ADB9-0BAF6F31B020}"/>
                  </a:ext>
                </a:extLst>
              </p:cNvPr>
              <p:cNvSpPr txBox="1"/>
              <p:nvPr/>
            </p:nvSpPr>
            <p:spPr>
              <a:xfrm>
                <a:off x="3655266" y="4934510"/>
                <a:ext cx="2344317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/>
                  <a:t>2-Dehydro-3-deoxy-D-galactonate</a:t>
                </a:r>
                <a:endParaRPr lang="en-US" sz="100" b="1" dirty="0"/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8C7F2DFC-F3A9-4C7C-AA0E-87AF1A423DDA}"/>
                </a:ext>
              </a:extLst>
            </p:cNvPr>
            <p:cNvGrpSpPr/>
            <p:nvPr/>
          </p:nvGrpSpPr>
          <p:grpSpPr>
            <a:xfrm>
              <a:off x="8660751" y="1836204"/>
              <a:ext cx="1710862" cy="261610"/>
              <a:chOff x="8910927" y="1492381"/>
              <a:chExt cx="1710862" cy="261610"/>
            </a:xfrm>
          </p:grpSpPr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EBBDF638-950C-41A8-9F2F-B7D423CC6F54}"/>
                  </a:ext>
                </a:extLst>
              </p:cNvPr>
              <p:cNvSpPr/>
              <p:nvPr/>
            </p:nvSpPr>
            <p:spPr>
              <a:xfrm>
                <a:off x="8910927" y="1531746"/>
                <a:ext cx="182880" cy="182880"/>
              </a:xfrm>
              <a:prstGeom prst="rect">
                <a:avLst/>
              </a:prstGeom>
              <a:solidFill>
                <a:srgbClr val="E4191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656CF9CE-4C8E-4A38-B769-6D9EB9A422FC}"/>
                  </a:ext>
                </a:extLst>
              </p:cNvPr>
              <p:cNvSpPr txBox="1"/>
              <p:nvPr/>
            </p:nvSpPr>
            <p:spPr>
              <a:xfrm>
                <a:off x="9093807" y="1492381"/>
                <a:ext cx="15279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Choline metabolism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500CD368-E358-4C15-883E-CB921EC75131}"/>
                </a:ext>
              </a:extLst>
            </p:cNvPr>
            <p:cNvGrpSpPr/>
            <p:nvPr/>
          </p:nvGrpSpPr>
          <p:grpSpPr>
            <a:xfrm>
              <a:off x="8660751" y="2176176"/>
              <a:ext cx="2592514" cy="261610"/>
              <a:chOff x="8910927" y="1753991"/>
              <a:chExt cx="2592514" cy="261610"/>
            </a:xfrm>
          </p:grpSpPr>
          <p:sp>
            <p:nvSpPr>
              <p:cNvPr id="17" name="Rectangle 16">
                <a:extLst>
                  <a:ext uri="{FF2B5EF4-FFF2-40B4-BE49-F238E27FC236}">
                    <a16:creationId xmlns:a16="http://schemas.microsoft.com/office/drawing/2014/main" id="{6AAAB8E5-6946-4053-A831-1946BA750260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1B1B7442-8BC9-4A9F-805E-5004AFACFC45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96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Glycerophospholipid metabolism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549460A5-4BE1-4E35-A88E-145A4859B2B8}"/>
                </a:ext>
              </a:extLst>
            </p:cNvPr>
            <p:cNvGrpSpPr/>
            <p:nvPr/>
          </p:nvGrpSpPr>
          <p:grpSpPr>
            <a:xfrm>
              <a:off x="8660751" y="2516148"/>
              <a:ext cx="2985250" cy="261610"/>
              <a:chOff x="8910927" y="1753991"/>
              <a:chExt cx="2985250" cy="261610"/>
            </a:xfrm>
          </p:grpSpPr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E9DD5960-B034-48E7-903B-FFFAF4F963CC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4C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22514728-8026-4780-B6D2-537AC1F3CF16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8023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trograde endocannabinoid signaling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1E93CD5C-9D67-4BEE-BA41-BEBE3979D4A5}"/>
                </a:ext>
              </a:extLst>
            </p:cNvPr>
            <p:cNvGrpSpPr/>
            <p:nvPr/>
          </p:nvGrpSpPr>
          <p:grpSpPr>
            <a:xfrm>
              <a:off x="8660751" y="2856120"/>
              <a:ext cx="2866628" cy="261610"/>
              <a:chOff x="8910927" y="1753991"/>
              <a:chExt cx="2866628" cy="261610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D2C71C7C-8A64-4BFF-968F-04B54598D44B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84D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9FABA16A-9F61-4CE6-AC8C-76EC677AE2D6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6837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thogenic Escherichia coli infec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10D22B55-3344-43DC-AB46-495B6E9223EB}"/>
                </a:ext>
              </a:extLst>
            </p:cNvPr>
            <p:cNvGrpSpPr/>
            <p:nvPr/>
          </p:nvGrpSpPr>
          <p:grpSpPr>
            <a:xfrm>
              <a:off x="8660751" y="3196092"/>
              <a:ext cx="2380918" cy="261610"/>
              <a:chOff x="8910927" y="1753991"/>
              <a:chExt cx="2380918" cy="261610"/>
            </a:xfrm>
          </p:grpSpPr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14403869-0CA5-43B3-A002-A414D7266136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FFF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28FBE0B6-0915-428F-9D27-0363822D7CB0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980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Steroid hormone biosynthesis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4387559B-6AB5-45E4-8F32-3F21BAB7B95B}"/>
                </a:ext>
              </a:extLst>
            </p:cNvPr>
            <p:cNvGrpSpPr/>
            <p:nvPr/>
          </p:nvGrpSpPr>
          <p:grpSpPr>
            <a:xfrm>
              <a:off x="8660751" y="3536064"/>
              <a:ext cx="2590912" cy="261610"/>
              <a:chOff x="8910927" y="1753991"/>
              <a:chExt cx="2590912" cy="261610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E9985957-5605-4174-901E-C125E434F315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A6562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7481E92D-AD73-4B24-A7A6-90EF651E544A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80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Vitamin digestion and absorp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ED033FDA-D1F7-495F-98A7-9BAEB09E2069}"/>
                </a:ext>
              </a:extLst>
            </p:cNvPr>
            <p:cNvGrpSpPr/>
            <p:nvPr/>
          </p:nvGrpSpPr>
          <p:grpSpPr>
            <a:xfrm>
              <a:off x="8660751" y="3876036"/>
              <a:ext cx="1880781" cy="261610"/>
              <a:chOff x="8910927" y="1753991"/>
              <a:chExt cx="1880781" cy="261610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3F11D77C-7528-4F68-9E98-E6CB45CB4B73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881BF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5A011D48-5A86-4F08-B6F2-B7FE0D8860DF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1697901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Galactose metabolism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F763F37E-D738-4653-A54C-3280FF16E7A4}"/>
                </a:ext>
              </a:extLst>
            </p:cNvPr>
            <p:cNvGrpSpPr/>
            <p:nvPr/>
          </p:nvGrpSpPr>
          <p:grpSpPr>
            <a:xfrm>
              <a:off x="8660751" y="4216009"/>
              <a:ext cx="2020242" cy="261610"/>
              <a:chOff x="8910927" y="1753991"/>
              <a:chExt cx="2020242" cy="261610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9DCDF650-8864-42AD-B9D7-A5DB2F61820E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999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653328BB-37EF-4013-BBD1-51CEB28E1825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183736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gulation of autophagy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1788191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4545041-4559-41A2-BA21-1E35E4D3891C}"/>
              </a:ext>
            </a:extLst>
          </p:cNvPr>
          <p:cNvSpPr txBox="1"/>
          <p:nvPr/>
        </p:nvSpPr>
        <p:spPr>
          <a:xfrm>
            <a:off x="1959429" y="5982647"/>
            <a:ext cx="7940351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ummary of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y metabolites that participate in various metabolic pathways whe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ng day 13 to the pre-irradiation timepoint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3" name="Group 2">
            <a:extLst>
              <a:ext uri="{FF2B5EF4-FFF2-40B4-BE49-F238E27FC236}">
                <a16:creationId xmlns:a16="http://schemas.microsoft.com/office/drawing/2014/main" id="{B79E6CE9-BCF1-4911-B08C-925A800FE923}"/>
              </a:ext>
            </a:extLst>
          </p:cNvPr>
          <p:cNvGrpSpPr/>
          <p:nvPr/>
        </p:nvGrpSpPr>
        <p:grpSpPr>
          <a:xfrm>
            <a:off x="2418655" y="0"/>
            <a:ext cx="9227346" cy="5410200"/>
            <a:chOff x="2418655" y="0"/>
            <a:chExt cx="9227346" cy="5410200"/>
          </a:xfrm>
        </p:grpSpPr>
        <p:grpSp>
          <p:nvGrpSpPr>
            <p:cNvPr id="2" name="Group 1">
              <a:extLst>
                <a:ext uri="{FF2B5EF4-FFF2-40B4-BE49-F238E27FC236}">
                  <a16:creationId xmlns:a16="http://schemas.microsoft.com/office/drawing/2014/main" id="{B877E93E-30F2-44B9-BE9E-A7BB0110DE35}"/>
                </a:ext>
              </a:extLst>
            </p:cNvPr>
            <p:cNvGrpSpPr/>
            <p:nvPr/>
          </p:nvGrpSpPr>
          <p:grpSpPr>
            <a:xfrm>
              <a:off x="2418655" y="0"/>
              <a:ext cx="6191945" cy="5410200"/>
              <a:chOff x="2418655" y="0"/>
              <a:chExt cx="6191945" cy="5410200"/>
            </a:xfrm>
          </p:grpSpPr>
          <p:pic>
            <p:nvPicPr>
              <p:cNvPr id="9" name="Picture 8">
                <a:extLst>
                  <a:ext uri="{FF2B5EF4-FFF2-40B4-BE49-F238E27FC236}">
                    <a16:creationId xmlns:a16="http://schemas.microsoft.com/office/drawing/2014/main" id="{6D2B7D70-CE7F-4763-9FCF-D7265F7F0CFB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0354"/>
              <a:stretch/>
            </p:blipFill>
            <p:spPr>
              <a:xfrm>
                <a:off x="3581400" y="0"/>
                <a:ext cx="5029200" cy="5410200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86DC6D51-7C99-492C-A57E-D35453D43497}"/>
                  </a:ext>
                </a:extLst>
              </p:cNvPr>
              <p:cNvSpPr txBox="1"/>
              <p:nvPr/>
            </p:nvSpPr>
            <p:spPr>
              <a:xfrm>
                <a:off x="3683398" y="265405"/>
                <a:ext cx="1851661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Glycero-3-phosphocholine</a:t>
                </a:r>
                <a:endParaRPr lang="en-US" sz="1200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041EDEB9-3DB8-4976-8679-50DE88363F83}"/>
                  </a:ext>
                </a:extLst>
              </p:cNvPr>
              <p:cNvSpPr txBox="1"/>
              <p:nvPr/>
            </p:nvSpPr>
            <p:spPr>
              <a:xfrm>
                <a:off x="2418655" y="913105"/>
                <a:ext cx="216771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alpha-Hydroxypregnenolone</a:t>
                </a:r>
                <a:endParaRPr lang="en-US" sz="10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E1B92693-FAB2-4AA0-AC56-7B757F8816AE}"/>
                  </a:ext>
                </a:extLst>
              </p:cNvPr>
              <p:cNvSpPr txBox="1"/>
              <p:nvPr/>
            </p:nvSpPr>
            <p:spPr>
              <a:xfrm>
                <a:off x="2895600" y="2035419"/>
                <a:ext cx="1093599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C(20:2/18:0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E509824-5FD3-4525-AA46-74408512EA20}"/>
                  </a:ext>
                </a:extLst>
              </p:cNvPr>
              <p:cNvSpPr txBox="1"/>
              <p:nvPr/>
            </p:nvSpPr>
            <p:spPr>
              <a:xfrm>
                <a:off x="2918085" y="3366749"/>
                <a:ext cx="1093599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E(22:6/18:2)</a:t>
                </a:r>
              </a:p>
              <a:p>
                <a:endParaRPr lang="en-US" sz="400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F48467E-CEDA-4000-939F-66A7FA8CA65A}"/>
                  </a:ext>
                </a:extLst>
              </p:cNvPr>
              <p:cNvSpPr txBox="1"/>
              <p:nvPr/>
            </p:nvSpPr>
            <p:spPr>
              <a:xfrm>
                <a:off x="3525372" y="4419252"/>
                <a:ext cx="105843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Androsterone</a:t>
                </a:r>
                <a:endParaRPr lang="en-US" sz="100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72F216B1-A6E5-4A32-80EA-6DC5233A353C}"/>
                  </a:ext>
                </a:extLst>
              </p:cNvPr>
              <p:cNvSpPr txBox="1"/>
              <p:nvPr/>
            </p:nvSpPr>
            <p:spPr>
              <a:xfrm>
                <a:off x="4609229" y="5062894"/>
                <a:ext cx="105843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estosterone</a:t>
                </a:r>
                <a:endParaRPr lang="en-US" sz="100" b="1" dirty="0"/>
              </a:p>
            </p:txBody>
          </p:sp>
        </p:grpSp>
        <p:grpSp>
          <p:nvGrpSpPr>
            <p:cNvPr id="12" name="Group 11">
              <a:extLst>
                <a:ext uri="{FF2B5EF4-FFF2-40B4-BE49-F238E27FC236}">
                  <a16:creationId xmlns:a16="http://schemas.microsoft.com/office/drawing/2014/main" id="{83C7E473-AA08-4267-BD84-2D21BD4C36C2}"/>
                </a:ext>
              </a:extLst>
            </p:cNvPr>
            <p:cNvGrpSpPr/>
            <p:nvPr/>
          </p:nvGrpSpPr>
          <p:grpSpPr>
            <a:xfrm>
              <a:off x="8660751" y="1836204"/>
              <a:ext cx="1710862" cy="261610"/>
              <a:chOff x="8910927" y="1492381"/>
              <a:chExt cx="1710862" cy="261610"/>
            </a:xfrm>
          </p:grpSpPr>
          <p:sp>
            <p:nvSpPr>
              <p:cNvPr id="13" name="Rectangle 12">
                <a:extLst>
                  <a:ext uri="{FF2B5EF4-FFF2-40B4-BE49-F238E27FC236}">
                    <a16:creationId xmlns:a16="http://schemas.microsoft.com/office/drawing/2014/main" id="{1FCB99AD-97B1-4409-A776-61EB96436F88}"/>
                  </a:ext>
                </a:extLst>
              </p:cNvPr>
              <p:cNvSpPr/>
              <p:nvPr/>
            </p:nvSpPr>
            <p:spPr>
              <a:xfrm>
                <a:off x="8910927" y="1531746"/>
                <a:ext cx="182880" cy="182880"/>
              </a:xfrm>
              <a:prstGeom prst="rect">
                <a:avLst/>
              </a:prstGeom>
              <a:solidFill>
                <a:srgbClr val="E4191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C65698CE-4680-4E3B-80B4-7038D783D8E0}"/>
                  </a:ext>
                </a:extLst>
              </p:cNvPr>
              <p:cNvSpPr txBox="1"/>
              <p:nvPr/>
            </p:nvSpPr>
            <p:spPr>
              <a:xfrm>
                <a:off x="9093807" y="1492381"/>
                <a:ext cx="15279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Choline metabolism</a:t>
                </a:r>
              </a:p>
            </p:txBody>
          </p:sp>
        </p:grpSp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A0A0B38B-F501-4F57-A9E0-4C919D11BF14}"/>
                </a:ext>
              </a:extLst>
            </p:cNvPr>
            <p:cNvGrpSpPr/>
            <p:nvPr/>
          </p:nvGrpSpPr>
          <p:grpSpPr>
            <a:xfrm>
              <a:off x="8660751" y="2176176"/>
              <a:ext cx="2592514" cy="261610"/>
              <a:chOff x="8910927" y="1753991"/>
              <a:chExt cx="2592514" cy="261610"/>
            </a:xfrm>
          </p:grpSpPr>
          <p:sp>
            <p:nvSpPr>
              <p:cNvPr id="16" name="Rectangle 15">
                <a:extLst>
                  <a:ext uri="{FF2B5EF4-FFF2-40B4-BE49-F238E27FC236}">
                    <a16:creationId xmlns:a16="http://schemas.microsoft.com/office/drawing/2014/main" id="{A981FCAD-0718-425D-8977-A70E4D4542E7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71192088-2E56-4AEE-934F-DA4C4DEB2976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96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Glycerophospholipid metabolism</a:t>
                </a:r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F2F899A9-2A21-4C6D-94D7-82F77B695C65}"/>
                </a:ext>
              </a:extLst>
            </p:cNvPr>
            <p:cNvGrpSpPr/>
            <p:nvPr/>
          </p:nvGrpSpPr>
          <p:grpSpPr>
            <a:xfrm>
              <a:off x="8660751" y="2516148"/>
              <a:ext cx="2985250" cy="261610"/>
              <a:chOff x="8910927" y="1753991"/>
              <a:chExt cx="2985250" cy="261610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EBE641D1-FD5C-4117-8AE1-B106D7530F3C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4C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681B077C-9DE3-4D05-A4EB-B10E7D31BB60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8023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trograde endocannabinoid signaling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3C388812-0377-4E1F-B86C-76868B2C4B6A}"/>
                </a:ext>
              </a:extLst>
            </p:cNvPr>
            <p:cNvGrpSpPr/>
            <p:nvPr/>
          </p:nvGrpSpPr>
          <p:grpSpPr>
            <a:xfrm>
              <a:off x="8660751" y="2856120"/>
              <a:ext cx="2866628" cy="261610"/>
              <a:chOff x="8910927" y="1753991"/>
              <a:chExt cx="2866628" cy="261610"/>
            </a:xfrm>
          </p:grpSpPr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5B742FA3-B285-44C7-84CC-8A63CC833788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84D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874F1165-FFCB-4215-9186-E8FE4958B000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6837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thogenic Escherichia coli infec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43F9CE36-FC48-493D-A38A-7D8C5D5A31AC}"/>
                </a:ext>
              </a:extLst>
            </p:cNvPr>
            <p:cNvGrpSpPr/>
            <p:nvPr/>
          </p:nvGrpSpPr>
          <p:grpSpPr>
            <a:xfrm>
              <a:off x="8660751" y="3196092"/>
              <a:ext cx="2380918" cy="261610"/>
              <a:chOff x="8910927" y="1753991"/>
              <a:chExt cx="2380918" cy="261610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0DD6E94F-1C33-462E-BB5A-3001E9CD19B4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FFF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E9DCFDD7-F8E8-4F39-8ECB-D3C52BD674B2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980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Steroid hormone biosynthesis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43447001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157F6636-66B1-4E83-9D3A-98A7025296C7}"/>
              </a:ext>
            </a:extLst>
          </p:cNvPr>
          <p:cNvSpPr txBox="1"/>
          <p:nvPr/>
        </p:nvSpPr>
        <p:spPr>
          <a:xfrm>
            <a:off x="2006082" y="5886810"/>
            <a:ext cx="671797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3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ummary of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y metabolites that participate in various metabolic pathways whe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ng day 25 to the pre-irradiation timepoint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BAED2892-6534-49E2-A8F4-1920EFDAE08F}"/>
              </a:ext>
            </a:extLst>
          </p:cNvPr>
          <p:cNvGrpSpPr/>
          <p:nvPr/>
        </p:nvGrpSpPr>
        <p:grpSpPr>
          <a:xfrm>
            <a:off x="2793101" y="338297"/>
            <a:ext cx="8852900" cy="5295900"/>
            <a:chOff x="2793101" y="338297"/>
            <a:chExt cx="8852900" cy="5295900"/>
          </a:xfrm>
        </p:grpSpPr>
        <p:grpSp>
          <p:nvGrpSpPr>
            <p:cNvPr id="3" name="Group 2">
              <a:extLst>
                <a:ext uri="{FF2B5EF4-FFF2-40B4-BE49-F238E27FC236}">
                  <a16:creationId xmlns:a16="http://schemas.microsoft.com/office/drawing/2014/main" id="{5B64B92B-0C12-4DEA-B3A6-6D0453E22EBB}"/>
                </a:ext>
              </a:extLst>
            </p:cNvPr>
            <p:cNvGrpSpPr/>
            <p:nvPr/>
          </p:nvGrpSpPr>
          <p:grpSpPr>
            <a:xfrm>
              <a:off x="2793101" y="338297"/>
              <a:ext cx="5817499" cy="5295900"/>
              <a:chOff x="2793101" y="0"/>
              <a:chExt cx="5817499" cy="5295900"/>
            </a:xfrm>
          </p:grpSpPr>
          <p:pic>
            <p:nvPicPr>
              <p:cNvPr id="7" name="Picture 6">
                <a:extLst>
                  <a:ext uri="{FF2B5EF4-FFF2-40B4-BE49-F238E27FC236}">
                    <a16:creationId xmlns:a16="http://schemas.microsoft.com/office/drawing/2014/main" id="{09A2E8A4-1CBF-4422-9CFE-451955A3978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2247"/>
              <a:stretch/>
            </p:blipFill>
            <p:spPr>
              <a:xfrm>
                <a:off x="3581400" y="0"/>
                <a:ext cx="5029200" cy="5295900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3C458491-4BFD-49DA-9C39-214F8DFC6974}"/>
                  </a:ext>
                </a:extLst>
              </p:cNvPr>
              <p:cNvSpPr txBox="1"/>
              <p:nvPr/>
            </p:nvSpPr>
            <p:spPr>
              <a:xfrm>
                <a:off x="3876957" y="261376"/>
                <a:ext cx="2305729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Glycero-3-phosphocholine</a:t>
                </a:r>
                <a:endParaRPr lang="en-US" sz="1200" dirty="0"/>
              </a:p>
            </p:txBody>
          </p:sp>
          <p:sp>
            <p:nvSpPr>
              <p:cNvPr id="6" name="TextBox 5">
                <a:extLst>
                  <a:ext uri="{FF2B5EF4-FFF2-40B4-BE49-F238E27FC236}">
                    <a16:creationId xmlns:a16="http://schemas.microsoft.com/office/drawing/2014/main" id="{BFE68021-A6D0-4892-8A2B-821ADE908685}"/>
                  </a:ext>
                </a:extLst>
              </p:cNvPr>
              <p:cNvSpPr txBox="1"/>
              <p:nvPr/>
            </p:nvSpPr>
            <p:spPr>
              <a:xfrm>
                <a:off x="2793101" y="603551"/>
                <a:ext cx="216771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alpha-Hydroxypregnenolone</a:t>
                </a:r>
                <a:endParaRPr lang="en-US" sz="1000" dirty="0"/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1491EB03-25A0-4AD8-885A-CF2FA3B88CDA}"/>
                  </a:ext>
                </a:extLst>
              </p:cNvPr>
              <p:cNvSpPr txBox="1"/>
              <p:nvPr/>
            </p:nvSpPr>
            <p:spPr>
              <a:xfrm>
                <a:off x="3174404" y="1240746"/>
                <a:ext cx="113880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C(20:2/18:0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B4F0221-25C0-4728-BC8F-DADE65B65DCA}"/>
                  </a:ext>
                </a:extLst>
              </p:cNvPr>
              <p:cNvSpPr txBox="1"/>
              <p:nvPr/>
            </p:nvSpPr>
            <p:spPr>
              <a:xfrm>
                <a:off x="2930577" y="2138199"/>
                <a:ext cx="1068616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E(22:6/18:2)</a:t>
                </a:r>
              </a:p>
              <a:p>
                <a:endParaRPr lang="en-US" sz="400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66C11771-9F17-4CFB-AAA3-79CCAD7FE07F}"/>
                  </a:ext>
                </a:extLst>
              </p:cNvPr>
              <p:cNvSpPr txBox="1"/>
              <p:nvPr/>
            </p:nvSpPr>
            <p:spPr>
              <a:xfrm>
                <a:off x="3969500" y="4541701"/>
                <a:ext cx="1013979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estosterone</a:t>
                </a:r>
                <a:endParaRPr lang="en-US" sz="100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B14F96DC-9CFB-468C-8A3D-0174AE8FB355}"/>
                  </a:ext>
                </a:extLst>
              </p:cNvPr>
              <p:cNvSpPr txBox="1"/>
              <p:nvPr/>
            </p:nvSpPr>
            <p:spPr>
              <a:xfrm>
                <a:off x="2846756" y="3059668"/>
                <a:ext cx="114472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5alpha-THDOC</a:t>
                </a:r>
                <a:endParaRPr lang="en-US" sz="100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8A56546A-3227-4D70-A7CE-5674DD300178}"/>
                  </a:ext>
                </a:extLst>
              </p:cNvPr>
              <p:cNvSpPr txBox="1"/>
              <p:nvPr/>
            </p:nvSpPr>
            <p:spPr>
              <a:xfrm>
                <a:off x="3195097" y="3895944"/>
                <a:ext cx="1137002" cy="292388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LysoPA</a:t>
                </a:r>
                <a:r>
                  <a:rPr lang="en-US" sz="1200" b="1" dirty="0"/>
                  <a:t>(18:2)</a:t>
                </a:r>
              </a:p>
              <a:p>
                <a:endParaRPr lang="en-US" sz="100" b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7119E5FE-A503-41BD-A3CE-AD9D2C326DF1}"/>
                  </a:ext>
                </a:extLst>
              </p:cNvPr>
              <p:cNvSpPr txBox="1"/>
              <p:nvPr/>
            </p:nvSpPr>
            <p:spPr>
              <a:xfrm>
                <a:off x="4476490" y="4876941"/>
                <a:ext cx="140078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2-Methoxyestrone</a:t>
                </a:r>
                <a:endParaRPr lang="en-US" sz="100" b="1" dirty="0"/>
              </a:p>
            </p:txBody>
          </p:sp>
        </p:grpSp>
        <p:grpSp>
          <p:nvGrpSpPr>
            <p:cNvPr id="14" name="Group 13">
              <a:extLst>
                <a:ext uri="{FF2B5EF4-FFF2-40B4-BE49-F238E27FC236}">
                  <a16:creationId xmlns:a16="http://schemas.microsoft.com/office/drawing/2014/main" id="{0F3008D4-B5B3-4594-BA77-0EC86E87D831}"/>
                </a:ext>
              </a:extLst>
            </p:cNvPr>
            <p:cNvGrpSpPr/>
            <p:nvPr/>
          </p:nvGrpSpPr>
          <p:grpSpPr>
            <a:xfrm>
              <a:off x="8660751" y="2184949"/>
              <a:ext cx="1710862" cy="261610"/>
              <a:chOff x="8910927" y="1492381"/>
              <a:chExt cx="1710862" cy="261610"/>
            </a:xfrm>
          </p:grpSpPr>
          <p:sp>
            <p:nvSpPr>
              <p:cNvPr id="15" name="Rectangle 14">
                <a:extLst>
                  <a:ext uri="{FF2B5EF4-FFF2-40B4-BE49-F238E27FC236}">
                    <a16:creationId xmlns:a16="http://schemas.microsoft.com/office/drawing/2014/main" id="{5B070EB4-5DA9-4F00-9B34-A9A7C8A22DB2}"/>
                  </a:ext>
                </a:extLst>
              </p:cNvPr>
              <p:cNvSpPr/>
              <p:nvPr/>
            </p:nvSpPr>
            <p:spPr>
              <a:xfrm>
                <a:off x="8910927" y="1531746"/>
                <a:ext cx="182880" cy="182880"/>
              </a:xfrm>
              <a:prstGeom prst="rect">
                <a:avLst/>
              </a:prstGeom>
              <a:solidFill>
                <a:srgbClr val="E4191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A025BD39-FABE-4304-9140-565F99381339}"/>
                  </a:ext>
                </a:extLst>
              </p:cNvPr>
              <p:cNvSpPr txBox="1"/>
              <p:nvPr/>
            </p:nvSpPr>
            <p:spPr>
              <a:xfrm>
                <a:off x="9093807" y="1492381"/>
                <a:ext cx="15279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Choline metabolism</a:t>
                </a:r>
              </a:p>
            </p:txBody>
          </p: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9D3386ED-8FA6-4C5C-B8C8-87E3FB9F63C6}"/>
                </a:ext>
              </a:extLst>
            </p:cNvPr>
            <p:cNvGrpSpPr/>
            <p:nvPr/>
          </p:nvGrpSpPr>
          <p:grpSpPr>
            <a:xfrm>
              <a:off x="8660751" y="2524243"/>
              <a:ext cx="2985250" cy="261610"/>
              <a:chOff x="8910927" y="1753991"/>
              <a:chExt cx="2985250" cy="261610"/>
            </a:xfrm>
          </p:grpSpPr>
          <p:sp>
            <p:nvSpPr>
              <p:cNvPr id="21" name="Rectangle 20">
                <a:extLst>
                  <a:ext uri="{FF2B5EF4-FFF2-40B4-BE49-F238E27FC236}">
                    <a16:creationId xmlns:a16="http://schemas.microsoft.com/office/drawing/2014/main" id="{1876F5A9-3CEC-4CBF-AAB9-B3ED2FC9C0C2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4C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9499DDCA-3AC7-4A9F-A025-737FB90E9D76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8023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trograde endocannabinoid signaling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A61CAB20-9341-4694-95A5-DF5795DDED8A}"/>
                </a:ext>
              </a:extLst>
            </p:cNvPr>
            <p:cNvGrpSpPr/>
            <p:nvPr/>
          </p:nvGrpSpPr>
          <p:grpSpPr>
            <a:xfrm>
              <a:off x="8660751" y="2864215"/>
              <a:ext cx="2866628" cy="261610"/>
              <a:chOff x="8910927" y="1753991"/>
              <a:chExt cx="2866628" cy="261610"/>
            </a:xfrm>
          </p:grpSpPr>
          <p:sp>
            <p:nvSpPr>
              <p:cNvPr id="24" name="Rectangle 23">
                <a:extLst>
                  <a:ext uri="{FF2B5EF4-FFF2-40B4-BE49-F238E27FC236}">
                    <a16:creationId xmlns:a16="http://schemas.microsoft.com/office/drawing/2014/main" id="{7A03522C-AF8D-46DA-9FC8-490DDA5D2791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84D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55C84C4C-FF7D-44A5-83E7-427B1A55AF0B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6837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thogenic Escherichia coli infec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6" name="Group 25">
              <a:extLst>
                <a:ext uri="{FF2B5EF4-FFF2-40B4-BE49-F238E27FC236}">
                  <a16:creationId xmlns:a16="http://schemas.microsoft.com/office/drawing/2014/main" id="{F71FCCEB-AEB5-4947-A37E-DBBFF9203590}"/>
                </a:ext>
              </a:extLst>
            </p:cNvPr>
            <p:cNvGrpSpPr/>
            <p:nvPr/>
          </p:nvGrpSpPr>
          <p:grpSpPr>
            <a:xfrm>
              <a:off x="8660751" y="3204187"/>
              <a:ext cx="2380918" cy="261610"/>
              <a:chOff x="8910927" y="1753991"/>
              <a:chExt cx="2380918" cy="261610"/>
            </a:xfrm>
          </p:grpSpPr>
          <p:sp>
            <p:nvSpPr>
              <p:cNvPr id="27" name="Rectangle 26">
                <a:extLst>
                  <a:ext uri="{FF2B5EF4-FFF2-40B4-BE49-F238E27FC236}">
                    <a16:creationId xmlns:a16="http://schemas.microsoft.com/office/drawing/2014/main" id="{06BA068B-BF07-4177-9C6D-9327EAB62A41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FFF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8" name="TextBox 27">
                <a:extLst>
                  <a:ext uri="{FF2B5EF4-FFF2-40B4-BE49-F238E27FC236}">
                    <a16:creationId xmlns:a16="http://schemas.microsoft.com/office/drawing/2014/main" id="{35CC39A2-8C3C-4A07-A5EA-4705F26872C5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980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Steroid hormone biosynthesis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9" name="Group 28">
              <a:extLst>
                <a:ext uri="{FF2B5EF4-FFF2-40B4-BE49-F238E27FC236}">
                  <a16:creationId xmlns:a16="http://schemas.microsoft.com/office/drawing/2014/main" id="{51CB1130-502B-4290-8B02-DEE4E4A27AE5}"/>
                </a:ext>
              </a:extLst>
            </p:cNvPr>
            <p:cNvGrpSpPr/>
            <p:nvPr/>
          </p:nvGrpSpPr>
          <p:grpSpPr>
            <a:xfrm>
              <a:off x="8660751" y="3544159"/>
              <a:ext cx="2590912" cy="261610"/>
              <a:chOff x="8910927" y="1753991"/>
              <a:chExt cx="2590912" cy="261610"/>
            </a:xfrm>
          </p:grpSpPr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9FF4D2FA-6A99-487B-9255-B50EAE23F3CC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A65627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1" name="TextBox 30">
                <a:extLst>
                  <a:ext uri="{FF2B5EF4-FFF2-40B4-BE49-F238E27FC236}">
                    <a16:creationId xmlns:a16="http://schemas.microsoft.com/office/drawing/2014/main" id="{06B99283-BF3A-4F63-AB9D-2EF968742246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803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Vitamin digestion and absorp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86908046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C57EDB6D-4189-46F7-B203-5E7BD780F3D5}"/>
              </a:ext>
            </a:extLst>
          </p:cNvPr>
          <p:cNvSpPr txBox="1"/>
          <p:nvPr/>
        </p:nvSpPr>
        <p:spPr>
          <a:xfrm>
            <a:off x="2146041" y="6119336"/>
            <a:ext cx="700610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4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ummary of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y metabolites that participate in various metabolic pathways whe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ng day 1 to the preterminal timepoint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42" name="Group 41">
            <a:extLst>
              <a:ext uri="{FF2B5EF4-FFF2-40B4-BE49-F238E27FC236}">
                <a16:creationId xmlns:a16="http://schemas.microsoft.com/office/drawing/2014/main" id="{441046A2-A41C-4DEF-8C81-E4D4A73DD501}"/>
              </a:ext>
            </a:extLst>
          </p:cNvPr>
          <p:cNvGrpSpPr/>
          <p:nvPr/>
        </p:nvGrpSpPr>
        <p:grpSpPr>
          <a:xfrm>
            <a:off x="2146041" y="423731"/>
            <a:ext cx="9499960" cy="5309267"/>
            <a:chOff x="2146041" y="423731"/>
            <a:chExt cx="9499960" cy="5309267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5502B42F-67F3-41E8-A4B6-0880438A6F0A}"/>
                </a:ext>
              </a:extLst>
            </p:cNvPr>
            <p:cNvGrpSpPr/>
            <p:nvPr/>
          </p:nvGrpSpPr>
          <p:grpSpPr>
            <a:xfrm>
              <a:off x="2146041" y="423731"/>
              <a:ext cx="6349583" cy="5309267"/>
              <a:chOff x="2261017" y="0"/>
              <a:chExt cx="6349583" cy="5309267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E8A0240F-1C31-465B-BF56-42FA04277629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2026"/>
              <a:stretch/>
            </p:blipFill>
            <p:spPr>
              <a:xfrm>
                <a:off x="3581400" y="0"/>
                <a:ext cx="5029200" cy="5309267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BBFCCE81-0CD0-4AB6-A6E0-8EF97C1CAE89}"/>
                  </a:ext>
                </a:extLst>
              </p:cNvPr>
              <p:cNvSpPr txBox="1"/>
              <p:nvPr/>
            </p:nvSpPr>
            <p:spPr>
              <a:xfrm>
                <a:off x="4003675" y="237256"/>
                <a:ext cx="192269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Glycero-3-phosphocholine</a:t>
                </a:r>
                <a:endParaRPr lang="en-US" sz="1200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F75A2EBE-C5D3-401B-A41D-4154AD756C23}"/>
                  </a:ext>
                </a:extLst>
              </p:cNvPr>
              <p:cNvSpPr txBox="1"/>
              <p:nvPr/>
            </p:nvSpPr>
            <p:spPr>
              <a:xfrm>
                <a:off x="3156431" y="460052"/>
                <a:ext cx="216771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alpha-Hydroxypregnenolone</a:t>
                </a:r>
                <a:endParaRPr lang="en-US" sz="10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88AE587B-311F-49D2-BE32-DCF794701304}"/>
                  </a:ext>
                </a:extLst>
              </p:cNvPr>
              <p:cNvSpPr txBox="1"/>
              <p:nvPr/>
            </p:nvSpPr>
            <p:spPr>
              <a:xfrm>
                <a:off x="3075366" y="1668344"/>
                <a:ext cx="106623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C(20:2/18:0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4E0010C3-0818-427F-935B-95A94B794CBB}"/>
                  </a:ext>
                </a:extLst>
              </p:cNvPr>
              <p:cNvSpPr txBox="1"/>
              <p:nvPr/>
            </p:nvSpPr>
            <p:spPr>
              <a:xfrm>
                <a:off x="3332362" y="1136621"/>
                <a:ext cx="1066233" cy="338554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E(22:6/18:2)</a:t>
                </a:r>
              </a:p>
              <a:p>
                <a:endParaRPr lang="en-US" sz="400" b="1" dirty="0"/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764D888B-C605-424C-8178-2E3C16686873}"/>
                  </a:ext>
                </a:extLst>
              </p:cNvPr>
              <p:cNvSpPr txBox="1"/>
              <p:nvPr/>
            </p:nvSpPr>
            <p:spPr>
              <a:xfrm>
                <a:off x="3420879" y="4037692"/>
                <a:ext cx="1013979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estosterone</a:t>
                </a:r>
                <a:endParaRPr lang="en-US" sz="100" b="1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0C34AF3C-E8F8-4851-B54D-E35AEE51766F}"/>
                  </a:ext>
                </a:extLst>
              </p:cNvPr>
              <p:cNvSpPr txBox="1"/>
              <p:nvPr/>
            </p:nvSpPr>
            <p:spPr>
              <a:xfrm>
                <a:off x="2875238" y="2279749"/>
                <a:ext cx="113700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LysoPA</a:t>
                </a:r>
                <a:r>
                  <a:rPr lang="en-US" sz="1200" b="1" dirty="0"/>
                  <a:t>(18:2)</a:t>
                </a:r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9858519F-F95A-494F-8239-29DBBD820540}"/>
                  </a:ext>
                </a:extLst>
              </p:cNvPr>
              <p:cNvSpPr txBox="1"/>
              <p:nvPr/>
            </p:nvSpPr>
            <p:spPr>
              <a:xfrm>
                <a:off x="3706433" y="754755"/>
                <a:ext cx="109833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riacylglycerol</a:t>
                </a:r>
                <a:endParaRPr lang="en-US" sz="100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9D40F4AE-2DC1-425E-AF38-FCE2E6883A0B}"/>
                  </a:ext>
                </a:extLst>
              </p:cNvPr>
              <p:cNvSpPr txBox="1"/>
              <p:nvPr/>
            </p:nvSpPr>
            <p:spPr>
              <a:xfrm>
                <a:off x="2261017" y="2891154"/>
                <a:ext cx="1745921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-Hydroxylinolenic acid</a:t>
                </a:r>
                <a:endParaRPr lang="en-US" sz="100" b="1" dirty="0"/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45BB65F-C46C-4D38-BDA9-75987B2D889D}"/>
                  </a:ext>
                </a:extLst>
              </p:cNvPr>
              <p:cNvSpPr txBox="1"/>
              <p:nvPr/>
            </p:nvSpPr>
            <p:spPr>
              <a:xfrm>
                <a:off x="2473128" y="3495037"/>
                <a:ext cx="164804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7-Dehydrodesmosterol</a:t>
                </a:r>
                <a:endParaRPr lang="en-US" sz="100" b="1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BB3E1685-97E3-4AFD-AB95-3977A7A1DBA4}"/>
                  </a:ext>
                </a:extLst>
              </p:cNvPr>
              <p:cNvSpPr txBox="1"/>
              <p:nvPr/>
            </p:nvSpPr>
            <p:spPr>
              <a:xfrm>
                <a:off x="2979177" y="4432172"/>
                <a:ext cx="1897381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alpha-Methylzymosterol</a:t>
                </a:r>
                <a:endParaRPr lang="en-US" sz="200" b="1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188C6DCC-9CBB-45B1-8794-6EF2084E8F32}"/>
                  </a:ext>
                </a:extLst>
              </p:cNvPr>
              <p:cNvSpPr txBox="1"/>
              <p:nvPr/>
            </p:nvSpPr>
            <p:spPr>
              <a:xfrm>
                <a:off x="4141599" y="4735529"/>
                <a:ext cx="122304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Stearidonic</a:t>
                </a:r>
                <a:r>
                  <a:rPr lang="en-US" sz="1200" b="1" dirty="0"/>
                  <a:t> acid</a:t>
                </a:r>
                <a:endParaRPr lang="en-US" sz="200" b="1" dirty="0"/>
              </a:p>
            </p:txBody>
          </p:sp>
          <p:sp>
            <p:nvSpPr>
              <p:cNvPr id="2" name="TextBox 1">
                <a:extLst>
                  <a:ext uri="{FF2B5EF4-FFF2-40B4-BE49-F238E27FC236}">
                    <a16:creationId xmlns:a16="http://schemas.microsoft.com/office/drawing/2014/main" id="{4224ED0E-7F1F-462C-B5AD-1D912CA616EF}"/>
                  </a:ext>
                </a:extLst>
              </p:cNvPr>
              <p:cNvSpPr txBox="1"/>
              <p:nvPr/>
            </p:nvSpPr>
            <p:spPr>
              <a:xfrm>
                <a:off x="5630461" y="4939935"/>
                <a:ext cx="444847" cy="369332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BCD4E30E-07CB-4BCE-B649-CD28DA424BB6}"/>
                  </a:ext>
                </a:extLst>
              </p:cNvPr>
              <p:cNvSpPr txBox="1"/>
              <p:nvPr/>
            </p:nvSpPr>
            <p:spPr>
              <a:xfrm>
                <a:off x="4796140" y="4937557"/>
                <a:ext cx="122304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elta8,14-Sterol</a:t>
                </a:r>
                <a:endParaRPr lang="en-US" sz="100" b="1" dirty="0"/>
              </a:p>
            </p:txBody>
          </p:sp>
        </p:grpSp>
        <p:grpSp>
          <p:nvGrpSpPr>
            <p:cNvPr id="18" name="Group 17">
              <a:extLst>
                <a:ext uri="{FF2B5EF4-FFF2-40B4-BE49-F238E27FC236}">
                  <a16:creationId xmlns:a16="http://schemas.microsoft.com/office/drawing/2014/main" id="{7CAC2637-56F6-4A3F-97F4-D3B82FBBDE4D}"/>
                </a:ext>
              </a:extLst>
            </p:cNvPr>
            <p:cNvGrpSpPr/>
            <p:nvPr/>
          </p:nvGrpSpPr>
          <p:grpSpPr>
            <a:xfrm>
              <a:off x="8660751" y="1836204"/>
              <a:ext cx="1710862" cy="261610"/>
              <a:chOff x="8910927" y="1492381"/>
              <a:chExt cx="1710862" cy="261610"/>
            </a:xfrm>
          </p:grpSpPr>
          <p:sp>
            <p:nvSpPr>
              <p:cNvPr id="19" name="Rectangle 18">
                <a:extLst>
                  <a:ext uri="{FF2B5EF4-FFF2-40B4-BE49-F238E27FC236}">
                    <a16:creationId xmlns:a16="http://schemas.microsoft.com/office/drawing/2014/main" id="{161FE88C-FB49-4674-A53C-87A5E9C3D562}"/>
                  </a:ext>
                </a:extLst>
              </p:cNvPr>
              <p:cNvSpPr/>
              <p:nvPr/>
            </p:nvSpPr>
            <p:spPr>
              <a:xfrm>
                <a:off x="8910927" y="1531746"/>
                <a:ext cx="182880" cy="182880"/>
              </a:xfrm>
              <a:prstGeom prst="rect">
                <a:avLst/>
              </a:prstGeom>
              <a:solidFill>
                <a:srgbClr val="E4191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9A284E29-FCC8-48C9-8EBF-EA7018D246D7}"/>
                  </a:ext>
                </a:extLst>
              </p:cNvPr>
              <p:cNvSpPr txBox="1"/>
              <p:nvPr/>
            </p:nvSpPr>
            <p:spPr>
              <a:xfrm>
                <a:off x="9093807" y="1492381"/>
                <a:ext cx="152798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Choline metabolism</a:t>
                </a:r>
              </a:p>
            </p:txBody>
          </p:sp>
        </p:grpSp>
        <p:grpSp>
          <p:nvGrpSpPr>
            <p:cNvPr id="21" name="Group 20">
              <a:extLst>
                <a:ext uri="{FF2B5EF4-FFF2-40B4-BE49-F238E27FC236}">
                  <a16:creationId xmlns:a16="http://schemas.microsoft.com/office/drawing/2014/main" id="{12EB4C57-0405-43BF-8F1E-4B483FEAD989}"/>
                </a:ext>
              </a:extLst>
            </p:cNvPr>
            <p:cNvGrpSpPr/>
            <p:nvPr/>
          </p:nvGrpSpPr>
          <p:grpSpPr>
            <a:xfrm>
              <a:off x="8660751" y="2176176"/>
              <a:ext cx="2592514" cy="261610"/>
              <a:chOff x="8910927" y="1753991"/>
              <a:chExt cx="2592514" cy="261610"/>
            </a:xfrm>
          </p:grpSpPr>
          <p:sp>
            <p:nvSpPr>
              <p:cNvPr id="22" name="Rectangle 21">
                <a:extLst>
                  <a:ext uri="{FF2B5EF4-FFF2-40B4-BE49-F238E27FC236}">
                    <a16:creationId xmlns:a16="http://schemas.microsoft.com/office/drawing/2014/main" id="{43EA7645-24EF-437F-AFF6-07EDB91912C9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E19936A5-E48F-47CF-BD35-6B16A2E49024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96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Glycerophospholipid metabolism</a:t>
                </a:r>
              </a:p>
            </p:txBody>
          </p:sp>
        </p:grpSp>
        <p:grpSp>
          <p:nvGrpSpPr>
            <p:cNvPr id="24" name="Group 23">
              <a:extLst>
                <a:ext uri="{FF2B5EF4-FFF2-40B4-BE49-F238E27FC236}">
                  <a16:creationId xmlns:a16="http://schemas.microsoft.com/office/drawing/2014/main" id="{346257D1-B888-44D0-AECC-CEA8827D073A}"/>
                </a:ext>
              </a:extLst>
            </p:cNvPr>
            <p:cNvGrpSpPr/>
            <p:nvPr/>
          </p:nvGrpSpPr>
          <p:grpSpPr>
            <a:xfrm>
              <a:off x="8660751" y="2516148"/>
              <a:ext cx="2985250" cy="261610"/>
              <a:chOff x="8910927" y="1753991"/>
              <a:chExt cx="2985250" cy="261610"/>
            </a:xfrm>
          </p:grpSpPr>
          <p:sp>
            <p:nvSpPr>
              <p:cNvPr id="25" name="Rectangle 24">
                <a:extLst>
                  <a:ext uri="{FF2B5EF4-FFF2-40B4-BE49-F238E27FC236}">
                    <a16:creationId xmlns:a16="http://schemas.microsoft.com/office/drawing/2014/main" id="{7FBC634F-ED47-4D9D-BF7D-32556B31879B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4C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0AC1E3D3-9795-43F4-9F66-01464E3600AC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8023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trograde endocannabinoid signaling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7" name="Group 26">
              <a:extLst>
                <a:ext uri="{FF2B5EF4-FFF2-40B4-BE49-F238E27FC236}">
                  <a16:creationId xmlns:a16="http://schemas.microsoft.com/office/drawing/2014/main" id="{23DDBBF4-7DA8-4E87-8942-08F820E7E3A4}"/>
                </a:ext>
              </a:extLst>
            </p:cNvPr>
            <p:cNvGrpSpPr/>
            <p:nvPr/>
          </p:nvGrpSpPr>
          <p:grpSpPr>
            <a:xfrm>
              <a:off x="8660751" y="2856120"/>
              <a:ext cx="2866628" cy="261610"/>
              <a:chOff x="8910927" y="1753991"/>
              <a:chExt cx="2866628" cy="261610"/>
            </a:xfrm>
          </p:grpSpPr>
          <p:sp>
            <p:nvSpPr>
              <p:cNvPr id="28" name="Rectangle 27">
                <a:extLst>
                  <a:ext uri="{FF2B5EF4-FFF2-40B4-BE49-F238E27FC236}">
                    <a16:creationId xmlns:a16="http://schemas.microsoft.com/office/drawing/2014/main" id="{E395B2CC-283F-45EA-B21D-917F587F27CB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84D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9" name="TextBox 28">
                <a:extLst>
                  <a:ext uri="{FF2B5EF4-FFF2-40B4-BE49-F238E27FC236}">
                    <a16:creationId xmlns:a16="http://schemas.microsoft.com/office/drawing/2014/main" id="{A9973837-5DAB-49E1-81CF-E76EC63972F4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6837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thogenic Escherichia coli infec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0" name="Group 29">
              <a:extLst>
                <a:ext uri="{FF2B5EF4-FFF2-40B4-BE49-F238E27FC236}">
                  <a16:creationId xmlns:a16="http://schemas.microsoft.com/office/drawing/2014/main" id="{483800FC-FC61-4BD1-B399-16CEB318330A}"/>
                </a:ext>
              </a:extLst>
            </p:cNvPr>
            <p:cNvGrpSpPr/>
            <p:nvPr/>
          </p:nvGrpSpPr>
          <p:grpSpPr>
            <a:xfrm>
              <a:off x="8660751" y="3196092"/>
              <a:ext cx="2380918" cy="261610"/>
              <a:chOff x="8910927" y="1753991"/>
              <a:chExt cx="2380918" cy="261610"/>
            </a:xfrm>
          </p:grpSpPr>
          <p:sp>
            <p:nvSpPr>
              <p:cNvPr id="31" name="Rectangle 30">
                <a:extLst>
                  <a:ext uri="{FF2B5EF4-FFF2-40B4-BE49-F238E27FC236}">
                    <a16:creationId xmlns:a16="http://schemas.microsoft.com/office/drawing/2014/main" id="{7CD1FCB5-B2EA-4F93-9136-501861BCF0F9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FFF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2" name="TextBox 31">
                <a:extLst>
                  <a:ext uri="{FF2B5EF4-FFF2-40B4-BE49-F238E27FC236}">
                    <a16:creationId xmlns:a16="http://schemas.microsoft.com/office/drawing/2014/main" id="{DA2BC5B7-02C2-400D-8EB0-E0D51882CE0A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980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Steroid hormone biosynthesis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3" name="Group 32">
              <a:extLst>
                <a:ext uri="{FF2B5EF4-FFF2-40B4-BE49-F238E27FC236}">
                  <a16:creationId xmlns:a16="http://schemas.microsoft.com/office/drawing/2014/main" id="{2931D795-4889-49ED-953B-B384682EE14D}"/>
                </a:ext>
              </a:extLst>
            </p:cNvPr>
            <p:cNvGrpSpPr/>
            <p:nvPr/>
          </p:nvGrpSpPr>
          <p:grpSpPr>
            <a:xfrm>
              <a:off x="8660751" y="3536064"/>
              <a:ext cx="2576484" cy="261610"/>
              <a:chOff x="8910927" y="1753991"/>
              <a:chExt cx="2576484" cy="261610"/>
            </a:xfrm>
          </p:grpSpPr>
          <p:sp>
            <p:nvSpPr>
              <p:cNvPr id="34" name="Rectangle 33">
                <a:extLst>
                  <a:ext uri="{FF2B5EF4-FFF2-40B4-BE49-F238E27FC236}">
                    <a16:creationId xmlns:a16="http://schemas.microsoft.com/office/drawing/2014/main" id="{41ACD437-EC40-407F-A297-8E0FE6B3682D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EDB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5" name="TextBox 34">
                <a:extLst>
                  <a:ext uri="{FF2B5EF4-FFF2-40B4-BE49-F238E27FC236}">
                    <a16:creationId xmlns:a16="http://schemas.microsoft.com/office/drawing/2014/main" id="{DD924FB3-4460-4FF4-9ECF-4671BBA9737E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39360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Alpha-Linolenic acid metabolism</a:t>
                </a:r>
              </a:p>
            </p:txBody>
          </p:sp>
        </p:grpSp>
        <p:grpSp>
          <p:nvGrpSpPr>
            <p:cNvPr id="36" name="Group 35">
              <a:extLst>
                <a:ext uri="{FF2B5EF4-FFF2-40B4-BE49-F238E27FC236}">
                  <a16:creationId xmlns:a16="http://schemas.microsoft.com/office/drawing/2014/main" id="{1CA922D7-06F5-4D87-8786-57C68A6D148E}"/>
                </a:ext>
              </a:extLst>
            </p:cNvPr>
            <p:cNvGrpSpPr/>
            <p:nvPr/>
          </p:nvGrpSpPr>
          <p:grpSpPr>
            <a:xfrm>
              <a:off x="8660751" y="3876036"/>
              <a:ext cx="2300767" cy="261610"/>
              <a:chOff x="8910927" y="1753991"/>
              <a:chExt cx="2300767" cy="261610"/>
            </a:xfrm>
          </p:grpSpPr>
          <p:sp>
            <p:nvSpPr>
              <p:cNvPr id="37" name="Rectangle 36">
                <a:extLst>
                  <a:ext uri="{FF2B5EF4-FFF2-40B4-BE49-F238E27FC236}">
                    <a16:creationId xmlns:a16="http://schemas.microsoft.com/office/drawing/2014/main" id="{ED0BED13-4248-40FB-822E-9D9B9B2E9C39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8DA0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8" name="TextBox 37">
                <a:extLst>
                  <a:ext uri="{FF2B5EF4-FFF2-40B4-BE49-F238E27FC236}">
                    <a16:creationId xmlns:a16="http://schemas.microsoft.com/office/drawing/2014/main" id="{EC512318-592C-4FDD-BA0E-BDE721367395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178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Fat digestion and absorp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1721DE97-422B-47A0-93E6-A38410986AC9}"/>
                </a:ext>
              </a:extLst>
            </p:cNvPr>
            <p:cNvGrpSpPr/>
            <p:nvPr/>
          </p:nvGrpSpPr>
          <p:grpSpPr>
            <a:xfrm>
              <a:off x="8660751" y="4216009"/>
              <a:ext cx="1598652" cy="261610"/>
              <a:chOff x="8910927" y="1753991"/>
              <a:chExt cx="1598652" cy="261610"/>
            </a:xfrm>
          </p:grpSpPr>
          <p:sp>
            <p:nvSpPr>
              <p:cNvPr id="40" name="Rectangle 39">
                <a:extLst>
                  <a:ext uri="{FF2B5EF4-FFF2-40B4-BE49-F238E27FC236}">
                    <a16:creationId xmlns:a16="http://schemas.microsoft.com/office/drawing/2014/main" id="{CBF1437F-8DB0-4A21-902B-3DD8240363E5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A6761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1" name="TextBox 40">
                <a:extLst>
                  <a:ext uri="{FF2B5EF4-FFF2-40B4-BE49-F238E27FC236}">
                    <a16:creationId xmlns:a16="http://schemas.microsoft.com/office/drawing/2014/main" id="{90012025-B65D-4E2D-A7DD-7CBF87901FE8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14157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ncreatic cancer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5142239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9461078A-D421-4B15-8DD8-B6ADA18CA671}"/>
              </a:ext>
            </a:extLst>
          </p:cNvPr>
          <p:cNvSpPr txBox="1"/>
          <p:nvPr/>
        </p:nvSpPr>
        <p:spPr>
          <a:xfrm>
            <a:off x="2015686" y="6119336"/>
            <a:ext cx="7221620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5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ummary of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y metabolites that participate in various metabolic pathways whe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ng day 13 to the preterminal timepoint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298BF54C-426B-494D-9F30-42C927309340}"/>
              </a:ext>
            </a:extLst>
          </p:cNvPr>
          <p:cNvGrpSpPr/>
          <p:nvPr/>
        </p:nvGrpSpPr>
        <p:grpSpPr>
          <a:xfrm>
            <a:off x="1974397" y="453360"/>
            <a:ext cx="9671604" cy="5328740"/>
            <a:chOff x="1974397" y="453360"/>
            <a:chExt cx="9671604" cy="5328740"/>
          </a:xfrm>
        </p:grpSpPr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540C0CA4-0B36-4C44-BF74-C0AAF2C79086}"/>
                </a:ext>
              </a:extLst>
            </p:cNvPr>
            <p:cNvGrpSpPr/>
            <p:nvPr/>
          </p:nvGrpSpPr>
          <p:grpSpPr>
            <a:xfrm>
              <a:off x="1974397" y="453360"/>
              <a:ext cx="6594914" cy="5328740"/>
              <a:chOff x="2015686" y="0"/>
              <a:chExt cx="6594914" cy="5328740"/>
            </a:xfrm>
          </p:grpSpPr>
          <p:pic>
            <p:nvPicPr>
              <p:cNvPr id="3" name="Picture 2">
                <a:extLst>
                  <a:ext uri="{FF2B5EF4-FFF2-40B4-BE49-F238E27FC236}">
                    <a16:creationId xmlns:a16="http://schemas.microsoft.com/office/drawing/2014/main" id="{BD896DE6-C393-4A3B-8036-CEF04881CAA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b="11703"/>
              <a:stretch/>
            </p:blipFill>
            <p:spPr>
              <a:xfrm>
                <a:off x="3581400" y="0"/>
                <a:ext cx="5029200" cy="5328740"/>
              </a:xfrm>
              <a:prstGeom prst="rect">
                <a:avLst/>
              </a:prstGeom>
            </p:spPr>
          </p:pic>
          <p:sp>
            <p:nvSpPr>
              <p:cNvPr id="4" name="TextBox 3">
                <a:extLst>
                  <a:ext uri="{FF2B5EF4-FFF2-40B4-BE49-F238E27FC236}">
                    <a16:creationId xmlns:a16="http://schemas.microsoft.com/office/drawing/2014/main" id="{6C0EB443-A799-4495-9AB7-7692C328EE85}"/>
                  </a:ext>
                </a:extLst>
              </p:cNvPr>
              <p:cNvSpPr txBox="1"/>
              <p:nvPr/>
            </p:nvSpPr>
            <p:spPr>
              <a:xfrm>
                <a:off x="4167705" y="90656"/>
                <a:ext cx="246833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Glycero-3-phosphocholine</a:t>
                </a:r>
                <a:endParaRPr lang="en-US" sz="1200" dirty="0"/>
              </a:p>
            </p:txBody>
          </p:sp>
          <p:sp>
            <p:nvSpPr>
              <p:cNvPr id="5" name="TextBox 4">
                <a:extLst>
                  <a:ext uri="{FF2B5EF4-FFF2-40B4-BE49-F238E27FC236}">
                    <a16:creationId xmlns:a16="http://schemas.microsoft.com/office/drawing/2014/main" id="{4FD3AC26-45B8-4521-B53D-6E50584A74C7}"/>
                  </a:ext>
                </a:extLst>
              </p:cNvPr>
              <p:cNvSpPr txBox="1"/>
              <p:nvPr/>
            </p:nvSpPr>
            <p:spPr>
              <a:xfrm>
                <a:off x="3446662" y="313506"/>
                <a:ext cx="216771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alpha-Hydroxypregnenolone</a:t>
                </a:r>
                <a:endParaRPr lang="en-US" sz="1000" dirty="0"/>
              </a:p>
            </p:txBody>
          </p:sp>
          <p:sp>
            <p:nvSpPr>
              <p:cNvPr id="7" name="TextBox 6">
                <a:extLst>
                  <a:ext uri="{FF2B5EF4-FFF2-40B4-BE49-F238E27FC236}">
                    <a16:creationId xmlns:a16="http://schemas.microsoft.com/office/drawing/2014/main" id="{055182E3-C091-44CD-A2CC-E100AEEC1E3D}"/>
                  </a:ext>
                </a:extLst>
              </p:cNvPr>
              <p:cNvSpPr txBox="1"/>
              <p:nvPr/>
            </p:nvSpPr>
            <p:spPr>
              <a:xfrm>
                <a:off x="3463908" y="1073882"/>
                <a:ext cx="1072686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C(20:2/18:0)</a:t>
                </a:r>
              </a:p>
            </p:txBody>
          </p:sp>
          <p:sp>
            <p:nvSpPr>
              <p:cNvPr id="8" name="TextBox 7">
                <a:extLst>
                  <a:ext uri="{FF2B5EF4-FFF2-40B4-BE49-F238E27FC236}">
                    <a16:creationId xmlns:a16="http://schemas.microsoft.com/office/drawing/2014/main" id="{6E3CDFB8-F40C-424A-A055-A13D5DD809C4}"/>
                  </a:ext>
                </a:extLst>
              </p:cNvPr>
              <p:cNvSpPr txBox="1"/>
              <p:nvPr/>
            </p:nvSpPr>
            <p:spPr>
              <a:xfrm>
                <a:off x="3701034" y="775686"/>
                <a:ext cx="105843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PE(22:6/18:2)</a:t>
                </a:r>
              </a:p>
            </p:txBody>
          </p:sp>
          <p:sp>
            <p:nvSpPr>
              <p:cNvPr id="9" name="TextBox 8">
                <a:extLst>
                  <a:ext uri="{FF2B5EF4-FFF2-40B4-BE49-F238E27FC236}">
                    <a16:creationId xmlns:a16="http://schemas.microsoft.com/office/drawing/2014/main" id="{CEE2E033-2832-413D-8444-CF61FD79E6DC}"/>
                  </a:ext>
                </a:extLst>
              </p:cNvPr>
              <p:cNvSpPr txBox="1"/>
              <p:nvPr/>
            </p:nvSpPr>
            <p:spPr>
              <a:xfrm>
                <a:off x="3508644" y="4132525"/>
                <a:ext cx="105843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Androsterone</a:t>
                </a:r>
                <a:endParaRPr lang="en-US" sz="100" b="1" dirty="0"/>
              </a:p>
            </p:txBody>
          </p:sp>
          <p:sp>
            <p:nvSpPr>
              <p:cNvPr id="11" name="TextBox 10">
                <a:extLst>
                  <a:ext uri="{FF2B5EF4-FFF2-40B4-BE49-F238E27FC236}">
                    <a16:creationId xmlns:a16="http://schemas.microsoft.com/office/drawing/2014/main" id="{FD4C2618-433B-4A4C-AA5E-332E817CF9F6}"/>
                  </a:ext>
                </a:extLst>
              </p:cNvPr>
              <p:cNvSpPr txBox="1"/>
              <p:nvPr/>
            </p:nvSpPr>
            <p:spPr>
              <a:xfrm>
                <a:off x="2987364" y="1791289"/>
                <a:ext cx="113700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5alpha-THDOC</a:t>
                </a:r>
                <a:endParaRPr lang="en-US" sz="100" b="1" dirty="0"/>
              </a:p>
            </p:txBody>
          </p:sp>
          <p:sp>
            <p:nvSpPr>
              <p:cNvPr id="12" name="TextBox 11">
                <a:extLst>
                  <a:ext uri="{FF2B5EF4-FFF2-40B4-BE49-F238E27FC236}">
                    <a16:creationId xmlns:a16="http://schemas.microsoft.com/office/drawing/2014/main" id="{C381B1F9-4E1D-4110-9E31-A22E5D19AE5B}"/>
                  </a:ext>
                </a:extLst>
              </p:cNvPr>
              <p:cNvSpPr txBox="1"/>
              <p:nvPr/>
            </p:nvSpPr>
            <p:spPr>
              <a:xfrm>
                <a:off x="2896428" y="2199094"/>
                <a:ext cx="113700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LysoPA</a:t>
                </a:r>
                <a:r>
                  <a:rPr lang="en-US" sz="1200" b="1" dirty="0"/>
                  <a:t>(18:2)</a:t>
                </a:r>
              </a:p>
            </p:txBody>
          </p:sp>
          <p:sp>
            <p:nvSpPr>
              <p:cNvPr id="13" name="TextBox 12">
                <a:extLst>
                  <a:ext uri="{FF2B5EF4-FFF2-40B4-BE49-F238E27FC236}">
                    <a16:creationId xmlns:a16="http://schemas.microsoft.com/office/drawing/2014/main" id="{0EBFB777-8AE1-49DE-B62E-C4DB0E508647}"/>
                  </a:ext>
                </a:extLst>
              </p:cNvPr>
              <p:cNvSpPr txBox="1"/>
              <p:nvPr/>
            </p:nvSpPr>
            <p:spPr>
              <a:xfrm>
                <a:off x="2405609" y="3450594"/>
                <a:ext cx="1745921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17-Hydroxylinolenic acid</a:t>
                </a:r>
                <a:endParaRPr lang="en-US" sz="100" b="1" dirty="0"/>
              </a:p>
            </p:txBody>
          </p:sp>
          <p:sp>
            <p:nvSpPr>
              <p:cNvPr id="14" name="TextBox 13">
                <a:extLst>
                  <a:ext uri="{FF2B5EF4-FFF2-40B4-BE49-F238E27FC236}">
                    <a16:creationId xmlns:a16="http://schemas.microsoft.com/office/drawing/2014/main" id="{1CEA9C25-6AE5-47D1-B023-EAD64CAB53A7}"/>
                  </a:ext>
                </a:extLst>
              </p:cNvPr>
              <p:cNvSpPr txBox="1"/>
              <p:nvPr/>
            </p:nvSpPr>
            <p:spPr>
              <a:xfrm>
                <a:off x="2678247" y="3811889"/>
                <a:ext cx="164804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7-Dehydrodesmosterol</a:t>
                </a:r>
                <a:endParaRPr lang="en-US" sz="100" b="1" dirty="0"/>
              </a:p>
            </p:txBody>
          </p:sp>
          <p:sp>
            <p:nvSpPr>
              <p:cNvPr id="16" name="TextBox 15">
                <a:extLst>
                  <a:ext uri="{FF2B5EF4-FFF2-40B4-BE49-F238E27FC236}">
                    <a16:creationId xmlns:a16="http://schemas.microsoft.com/office/drawing/2014/main" id="{24B2E60E-BD85-47F4-BD45-0FE7F6AC04B8}"/>
                  </a:ext>
                </a:extLst>
              </p:cNvPr>
              <p:cNvSpPr txBox="1"/>
              <p:nvPr/>
            </p:nvSpPr>
            <p:spPr>
              <a:xfrm>
                <a:off x="2015686" y="2583845"/>
                <a:ext cx="201597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5alpha-Pregnane-3,20-dione</a:t>
                </a:r>
                <a:endParaRPr lang="en-US" sz="100" b="1" dirty="0"/>
              </a:p>
            </p:txBody>
          </p:sp>
          <p:sp>
            <p:nvSpPr>
              <p:cNvPr id="17" name="TextBox 16">
                <a:extLst>
                  <a:ext uri="{FF2B5EF4-FFF2-40B4-BE49-F238E27FC236}">
                    <a16:creationId xmlns:a16="http://schemas.microsoft.com/office/drawing/2014/main" id="{43FCC49A-6D1A-4ADB-BD4A-33488728866B}"/>
                  </a:ext>
                </a:extLst>
              </p:cNvPr>
              <p:cNvSpPr txBox="1"/>
              <p:nvPr/>
            </p:nvSpPr>
            <p:spPr>
              <a:xfrm>
                <a:off x="2841642" y="3017556"/>
                <a:ext cx="121587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Stearidonic</a:t>
                </a:r>
                <a:r>
                  <a:rPr lang="en-US" sz="1200" b="1" dirty="0"/>
                  <a:t> acid</a:t>
                </a:r>
                <a:endParaRPr lang="en-US" sz="100" b="1" dirty="0"/>
              </a:p>
            </p:txBody>
          </p:sp>
          <p:sp>
            <p:nvSpPr>
              <p:cNvPr id="19" name="TextBox 18">
                <a:extLst>
                  <a:ext uri="{FF2B5EF4-FFF2-40B4-BE49-F238E27FC236}">
                    <a16:creationId xmlns:a16="http://schemas.microsoft.com/office/drawing/2014/main" id="{0ED5F2CD-418D-48DE-A5B3-60AEC19DE452}"/>
                  </a:ext>
                </a:extLst>
              </p:cNvPr>
              <p:cNvSpPr txBox="1"/>
              <p:nvPr/>
            </p:nvSpPr>
            <p:spPr>
              <a:xfrm>
                <a:off x="4901349" y="5051741"/>
                <a:ext cx="1262763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Delta8,14-Sterol</a:t>
                </a:r>
                <a:endParaRPr lang="en-US" sz="100" b="1" dirty="0"/>
              </a:p>
            </p:txBody>
          </p:sp>
          <p:sp>
            <p:nvSpPr>
              <p:cNvPr id="20" name="TextBox 19">
                <a:extLst>
                  <a:ext uri="{FF2B5EF4-FFF2-40B4-BE49-F238E27FC236}">
                    <a16:creationId xmlns:a16="http://schemas.microsoft.com/office/drawing/2014/main" id="{DEF3B5A6-F88C-4FF7-B76A-99E3FD4E4D9B}"/>
                  </a:ext>
                </a:extLst>
              </p:cNvPr>
              <p:cNvSpPr txBox="1"/>
              <p:nvPr/>
            </p:nvSpPr>
            <p:spPr>
              <a:xfrm>
                <a:off x="3446662" y="1382879"/>
                <a:ext cx="864094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 err="1"/>
                  <a:t>Traumatin</a:t>
                </a:r>
                <a:endParaRPr lang="en-US" sz="100" b="1" dirty="0"/>
              </a:p>
            </p:txBody>
          </p:sp>
          <p:sp>
            <p:nvSpPr>
              <p:cNvPr id="18" name="TextBox 17">
                <a:extLst>
                  <a:ext uri="{FF2B5EF4-FFF2-40B4-BE49-F238E27FC236}">
                    <a16:creationId xmlns:a16="http://schemas.microsoft.com/office/drawing/2014/main" id="{FF3ABC67-07A5-4A4A-B305-57D66CA567C5}"/>
                  </a:ext>
                </a:extLst>
              </p:cNvPr>
              <p:cNvSpPr txBox="1"/>
              <p:nvPr/>
            </p:nvSpPr>
            <p:spPr>
              <a:xfrm>
                <a:off x="4385698" y="4839769"/>
                <a:ext cx="132153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Allopregnanolone</a:t>
                </a:r>
                <a:endParaRPr lang="en-US" sz="100" b="1" dirty="0"/>
              </a:p>
            </p:txBody>
          </p:sp>
          <p:sp>
            <p:nvSpPr>
              <p:cNvPr id="21" name="TextBox 20">
                <a:extLst>
                  <a:ext uri="{FF2B5EF4-FFF2-40B4-BE49-F238E27FC236}">
                    <a16:creationId xmlns:a16="http://schemas.microsoft.com/office/drawing/2014/main" id="{9BF8D950-B795-4952-A522-8BA76BFFE357}"/>
                  </a:ext>
                </a:extLst>
              </p:cNvPr>
              <p:cNvSpPr txBox="1"/>
              <p:nvPr/>
            </p:nvSpPr>
            <p:spPr>
              <a:xfrm>
                <a:off x="4295938" y="4468251"/>
                <a:ext cx="564630" cy="46776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endParaRPr lang="en-US" dirty="0"/>
              </a:p>
            </p:txBody>
          </p:sp>
          <p:sp>
            <p:nvSpPr>
              <p:cNvPr id="10" name="TextBox 9">
                <a:extLst>
                  <a:ext uri="{FF2B5EF4-FFF2-40B4-BE49-F238E27FC236}">
                    <a16:creationId xmlns:a16="http://schemas.microsoft.com/office/drawing/2014/main" id="{DA538685-F911-4C43-B6F0-3443CDB008B9}"/>
                  </a:ext>
                </a:extLst>
              </p:cNvPr>
              <p:cNvSpPr txBox="1"/>
              <p:nvPr/>
            </p:nvSpPr>
            <p:spPr>
              <a:xfrm>
                <a:off x="3866770" y="4421066"/>
                <a:ext cx="1013979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estosterone</a:t>
                </a:r>
                <a:endParaRPr lang="en-US" sz="100" b="1" dirty="0"/>
              </a:p>
            </p:txBody>
          </p:sp>
          <p:sp>
            <p:nvSpPr>
              <p:cNvPr id="15" name="TextBox 14">
                <a:extLst>
                  <a:ext uri="{FF2B5EF4-FFF2-40B4-BE49-F238E27FC236}">
                    <a16:creationId xmlns:a16="http://schemas.microsoft.com/office/drawing/2014/main" id="{3052477C-1CF1-48D9-8DE8-B8B8B6B67A35}"/>
                  </a:ext>
                </a:extLst>
              </p:cNvPr>
              <p:cNvSpPr txBox="1"/>
              <p:nvPr/>
            </p:nvSpPr>
            <p:spPr>
              <a:xfrm>
                <a:off x="3368074" y="4645634"/>
                <a:ext cx="1858042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4alpha-Methylzymosterol</a:t>
                </a:r>
                <a:endParaRPr lang="en-US" sz="200" b="1" dirty="0"/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B264FB6C-E7AB-49C7-A89F-8E5F3D32D6A7}"/>
                  </a:ext>
                </a:extLst>
              </p:cNvPr>
              <p:cNvSpPr txBox="1"/>
              <p:nvPr/>
            </p:nvSpPr>
            <p:spPr>
              <a:xfrm>
                <a:off x="5724693" y="350103"/>
                <a:ext cx="360990" cy="2000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endParaRPr lang="en-US" sz="700" dirty="0"/>
              </a:p>
            </p:txBody>
          </p:sp>
          <p:sp>
            <p:nvSpPr>
              <p:cNvPr id="26" name="TextBox 25">
                <a:extLst>
                  <a:ext uri="{FF2B5EF4-FFF2-40B4-BE49-F238E27FC236}">
                    <a16:creationId xmlns:a16="http://schemas.microsoft.com/office/drawing/2014/main" id="{B6C37610-198D-4460-8B64-D4EA40AB0384}"/>
                  </a:ext>
                </a:extLst>
              </p:cNvPr>
              <p:cNvSpPr txBox="1"/>
              <p:nvPr/>
            </p:nvSpPr>
            <p:spPr>
              <a:xfrm>
                <a:off x="4865126" y="536356"/>
                <a:ext cx="360990" cy="2000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endParaRPr lang="en-US" sz="700" dirty="0"/>
              </a:p>
            </p:txBody>
          </p:sp>
          <p:sp>
            <p:nvSpPr>
              <p:cNvPr id="22" name="TextBox 21">
                <a:extLst>
                  <a:ext uri="{FF2B5EF4-FFF2-40B4-BE49-F238E27FC236}">
                    <a16:creationId xmlns:a16="http://schemas.microsoft.com/office/drawing/2014/main" id="{39178EC3-DB69-450C-8F46-57887ABF8A9F}"/>
                  </a:ext>
                </a:extLst>
              </p:cNvPr>
              <p:cNvSpPr txBox="1"/>
              <p:nvPr/>
            </p:nvSpPr>
            <p:spPr>
              <a:xfrm>
                <a:off x="4048495" y="532290"/>
                <a:ext cx="1090870" cy="276999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r>
                  <a:rPr lang="en-US" sz="1200" b="1" dirty="0"/>
                  <a:t>Triacylglycerol</a:t>
                </a:r>
                <a:endParaRPr lang="en-US" sz="700" b="1" dirty="0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C398C99A-DC9E-4EA0-A268-EA4C46EDB3E1}"/>
                  </a:ext>
                </a:extLst>
              </p:cNvPr>
              <p:cNvSpPr txBox="1"/>
              <p:nvPr/>
            </p:nvSpPr>
            <p:spPr>
              <a:xfrm>
                <a:off x="5871646" y="4909566"/>
                <a:ext cx="360990" cy="20005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endParaRPr lang="en-US" sz="700" dirty="0"/>
              </a:p>
            </p:txBody>
          </p:sp>
        </p:grpSp>
        <p:grpSp>
          <p:nvGrpSpPr>
            <p:cNvPr id="32" name="Group 31">
              <a:extLst>
                <a:ext uri="{FF2B5EF4-FFF2-40B4-BE49-F238E27FC236}">
                  <a16:creationId xmlns:a16="http://schemas.microsoft.com/office/drawing/2014/main" id="{6943FC2D-9CBF-45AE-BAA8-67D87891DEA9}"/>
                </a:ext>
              </a:extLst>
            </p:cNvPr>
            <p:cNvGrpSpPr/>
            <p:nvPr/>
          </p:nvGrpSpPr>
          <p:grpSpPr>
            <a:xfrm>
              <a:off x="8660751" y="2176176"/>
              <a:ext cx="2592514" cy="261610"/>
              <a:chOff x="8910927" y="1753991"/>
              <a:chExt cx="2592514" cy="261610"/>
            </a:xfrm>
          </p:grpSpPr>
          <p:sp>
            <p:nvSpPr>
              <p:cNvPr id="33" name="Rectangle 32">
                <a:extLst>
                  <a:ext uri="{FF2B5EF4-FFF2-40B4-BE49-F238E27FC236}">
                    <a16:creationId xmlns:a16="http://schemas.microsoft.com/office/drawing/2014/main" id="{5AB9EEF8-B88D-44ED-823D-4CC9A4C6C5C9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4" name="TextBox 33">
                <a:extLst>
                  <a:ext uri="{FF2B5EF4-FFF2-40B4-BE49-F238E27FC236}">
                    <a16:creationId xmlns:a16="http://schemas.microsoft.com/office/drawing/2014/main" id="{660B5B0C-568B-44DF-82EF-8E6B37941911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96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Glycerophospholipid metabolism</a:t>
                </a:r>
              </a:p>
            </p:txBody>
          </p:sp>
        </p:grpSp>
        <p:grpSp>
          <p:nvGrpSpPr>
            <p:cNvPr id="35" name="Group 34">
              <a:extLst>
                <a:ext uri="{FF2B5EF4-FFF2-40B4-BE49-F238E27FC236}">
                  <a16:creationId xmlns:a16="http://schemas.microsoft.com/office/drawing/2014/main" id="{2D24DA9C-06C7-4719-83FC-13B9344FBFD5}"/>
                </a:ext>
              </a:extLst>
            </p:cNvPr>
            <p:cNvGrpSpPr/>
            <p:nvPr/>
          </p:nvGrpSpPr>
          <p:grpSpPr>
            <a:xfrm>
              <a:off x="8660751" y="2516148"/>
              <a:ext cx="2985250" cy="261610"/>
              <a:chOff x="8910927" y="1753991"/>
              <a:chExt cx="2985250" cy="261610"/>
            </a:xfrm>
          </p:grpSpPr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8719AA3A-EB42-458D-92DA-575E7CD92492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99999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7" name="TextBox 36">
                <a:extLst>
                  <a:ext uri="{FF2B5EF4-FFF2-40B4-BE49-F238E27FC236}">
                    <a16:creationId xmlns:a16="http://schemas.microsoft.com/office/drawing/2014/main" id="{04274404-841B-43E5-B74C-F895F324E455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8023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trograde endocannabinoid signaling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8" name="Group 37">
              <a:extLst>
                <a:ext uri="{FF2B5EF4-FFF2-40B4-BE49-F238E27FC236}">
                  <a16:creationId xmlns:a16="http://schemas.microsoft.com/office/drawing/2014/main" id="{AB615B8A-FFF2-43AC-ABE7-330D0CB863A8}"/>
                </a:ext>
              </a:extLst>
            </p:cNvPr>
            <p:cNvGrpSpPr/>
            <p:nvPr/>
          </p:nvGrpSpPr>
          <p:grpSpPr>
            <a:xfrm>
              <a:off x="8660751" y="2856120"/>
              <a:ext cx="2866628" cy="261610"/>
              <a:chOff x="8910927" y="1753991"/>
              <a:chExt cx="2866628" cy="261610"/>
            </a:xfrm>
          </p:grpSpPr>
          <p:sp>
            <p:nvSpPr>
              <p:cNvPr id="39" name="Rectangle 38">
                <a:extLst>
                  <a:ext uri="{FF2B5EF4-FFF2-40B4-BE49-F238E27FC236}">
                    <a16:creationId xmlns:a16="http://schemas.microsoft.com/office/drawing/2014/main" id="{2DF07DF3-2097-4F3C-84A0-68728B785372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84D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0" name="TextBox 39">
                <a:extLst>
                  <a:ext uri="{FF2B5EF4-FFF2-40B4-BE49-F238E27FC236}">
                    <a16:creationId xmlns:a16="http://schemas.microsoft.com/office/drawing/2014/main" id="{D10B30E9-F5FD-4458-BFDC-B7AAA50CE111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6837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thogenic Escherichia coli infec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41" name="Group 40">
              <a:extLst>
                <a:ext uri="{FF2B5EF4-FFF2-40B4-BE49-F238E27FC236}">
                  <a16:creationId xmlns:a16="http://schemas.microsoft.com/office/drawing/2014/main" id="{852D23E1-C4B8-4C9F-9670-1241EB6F3570}"/>
                </a:ext>
              </a:extLst>
            </p:cNvPr>
            <p:cNvGrpSpPr/>
            <p:nvPr/>
          </p:nvGrpSpPr>
          <p:grpSpPr>
            <a:xfrm>
              <a:off x="8660751" y="3196092"/>
              <a:ext cx="2380918" cy="261610"/>
              <a:chOff x="8910927" y="1753991"/>
              <a:chExt cx="2380918" cy="261610"/>
            </a:xfrm>
          </p:grpSpPr>
          <p:sp>
            <p:nvSpPr>
              <p:cNvPr id="42" name="Rectangle 41">
                <a:extLst>
                  <a:ext uri="{FF2B5EF4-FFF2-40B4-BE49-F238E27FC236}">
                    <a16:creationId xmlns:a16="http://schemas.microsoft.com/office/drawing/2014/main" id="{85702D52-1448-4FB7-97CE-0EDFD384D050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FFF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3" name="TextBox 42">
                <a:extLst>
                  <a:ext uri="{FF2B5EF4-FFF2-40B4-BE49-F238E27FC236}">
                    <a16:creationId xmlns:a16="http://schemas.microsoft.com/office/drawing/2014/main" id="{23953117-9900-4D83-A532-906F0643040B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980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Steroid hormone biosynthesis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44" name="Group 43">
              <a:extLst>
                <a:ext uri="{FF2B5EF4-FFF2-40B4-BE49-F238E27FC236}">
                  <a16:creationId xmlns:a16="http://schemas.microsoft.com/office/drawing/2014/main" id="{EE3578D2-1816-490C-8E96-B30F3F54B1CB}"/>
                </a:ext>
              </a:extLst>
            </p:cNvPr>
            <p:cNvGrpSpPr/>
            <p:nvPr/>
          </p:nvGrpSpPr>
          <p:grpSpPr>
            <a:xfrm>
              <a:off x="8660751" y="3536064"/>
              <a:ext cx="2576484" cy="261610"/>
              <a:chOff x="8910927" y="1753991"/>
              <a:chExt cx="2576484" cy="261610"/>
            </a:xfrm>
          </p:grpSpPr>
          <p:sp>
            <p:nvSpPr>
              <p:cNvPr id="45" name="Rectangle 44">
                <a:extLst>
                  <a:ext uri="{FF2B5EF4-FFF2-40B4-BE49-F238E27FC236}">
                    <a16:creationId xmlns:a16="http://schemas.microsoft.com/office/drawing/2014/main" id="{4476832E-5975-4A02-B64C-121BAA612460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EDB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6" name="TextBox 45">
                <a:extLst>
                  <a:ext uri="{FF2B5EF4-FFF2-40B4-BE49-F238E27FC236}">
                    <a16:creationId xmlns:a16="http://schemas.microsoft.com/office/drawing/2014/main" id="{8722AFFE-8CAD-4462-8016-4641A2DC7BBD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39360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Alpha-Linolenic acid metabolism</a:t>
                </a:r>
              </a:p>
            </p:txBody>
          </p:sp>
        </p:grpSp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3059CC2E-B512-40CC-B41D-0A0F8EA57665}"/>
                </a:ext>
              </a:extLst>
            </p:cNvPr>
            <p:cNvGrpSpPr/>
            <p:nvPr/>
          </p:nvGrpSpPr>
          <p:grpSpPr>
            <a:xfrm>
              <a:off x="8660751" y="3876036"/>
              <a:ext cx="2300767" cy="261610"/>
              <a:chOff x="8910927" y="1753991"/>
              <a:chExt cx="2300767" cy="261610"/>
            </a:xfrm>
          </p:grpSpPr>
          <p:sp>
            <p:nvSpPr>
              <p:cNvPr id="48" name="Rectangle 47">
                <a:extLst>
                  <a:ext uri="{FF2B5EF4-FFF2-40B4-BE49-F238E27FC236}">
                    <a16:creationId xmlns:a16="http://schemas.microsoft.com/office/drawing/2014/main" id="{C6C9F529-FB88-4992-80A7-8B630E6AB40E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8DA0CB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9" name="TextBox 48">
                <a:extLst>
                  <a:ext uri="{FF2B5EF4-FFF2-40B4-BE49-F238E27FC236}">
                    <a16:creationId xmlns:a16="http://schemas.microsoft.com/office/drawing/2014/main" id="{146B44BD-9904-414B-88AB-EC9C50B8E4B7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17887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Fat digestion and absorp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F8E06EC3-DEB9-4015-823D-3933F3906066}"/>
                </a:ext>
              </a:extLst>
            </p:cNvPr>
            <p:cNvGrpSpPr/>
            <p:nvPr/>
          </p:nvGrpSpPr>
          <p:grpSpPr>
            <a:xfrm>
              <a:off x="8660751" y="4216009"/>
              <a:ext cx="1598652" cy="261610"/>
              <a:chOff x="8910927" y="1753991"/>
              <a:chExt cx="1598652" cy="261610"/>
            </a:xfrm>
          </p:grpSpPr>
          <p:sp>
            <p:nvSpPr>
              <p:cNvPr id="51" name="Rectangle 50">
                <a:extLst>
                  <a:ext uri="{FF2B5EF4-FFF2-40B4-BE49-F238E27FC236}">
                    <a16:creationId xmlns:a16="http://schemas.microsoft.com/office/drawing/2014/main" id="{3FC1F73E-DCDA-4DF7-8BEB-773EBA6E7C45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A6761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52" name="TextBox 51">
                <a:extLst>
                  <a:ext uri="{FF2B5EF4-FFF2-40B4-BE49-F238E27FC236}">
                    <a16:creationId xmlns:a16="http://schemas.microsoft.com/office/drawing/2014/main" id="{9EC07681-7DF8-4450-A87A-2246E9E8348D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14157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ncreatic cancer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sp>
          <p:nvSpPr>
            <p:cNvPr id="24" name="TextBox 23">
              <a:extLst>
                <a:ext uri="{FF2B5EF4-FFF2-40B4-BE49-F238E27FC236}">
                  <a16:creationId xmlns:a16="http://schemas.microsoft.com/office/drawing/2014/main" id="{BCFD8F31-339D-4209-9D15-E7DB0673A302}"/>
                </a:ext>
              </a:extLst>
            </p:cNvPr>
            <p:cNvSpPr txBox="1"/>
            <p:nvPr/>
          </p:nvSpPr>
          <p:spPr>
            <a:xfrm>
              <a:off x="4604052" y="1189771"/>
              <a:ext cx="215227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square" rtlCol="0">
              <a:spAutoFit/>
            </a:bodyPr>
            <a:lstStyle/>
            <a:p>
              <a:endParaRPr lang="en-US" sz="1050" dirty="0"/>
            </a:p>
          </p:txBody>
        </p:sp>
      </p:grpSp>
    </p:spTree>
    <p:extLst>
      <p:ext uri="{BB962C8B-B14F-4D97-AF65-F5344CB8AC3E}">
        <p14:creationId xmlns:p14="http://schemas.microsoft.com/office/powerpoint/2010/main" val="106963850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DDC6D2FB-6075-4C6C-90F6-789DE539D402}"/>
              </a:ext>
            </a:extLst>
          </p:cNvPr>
          <p:cNvSpPr txBox="1"/>
          <p:nvPr/>
        </p:nvSpPr>
        <p:spPr>
          <a:xfrm>
            <a:off x="1996750" y="6102517"/>
            <a:ext cx="737118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400" b="1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6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summary of 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ey metabolites that participate in various metabolic pathways when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mparing day 25 to the preterminal timepoint</a:t>
            </a:r>
            <a:r>
              <a:rPr lang="en-US" sz="1400" dirty="0">
                <a:solidFill>
                  <a:prstClr val="black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</a:p>
        </p:txBody>
      </p:sp>
      <p:grpSp>
        <p:nvGrpSpPr>
          <p:cNvPr id="19" name="Group 18">
            <a:extLst>
              <a:ext uri="{FF2B5EF4-FFF2-40B4-BE49-F238E27FC236}">
                <a16:creationId xmlns:a16="http://schemas.microsoft.com/office/drawing/2014/main" id="{DEB32921-9867-4B44-8605-0504D7B63EC8}"/>
              </a:ext>
            </a:extLst>
          </p:cNvPr>
          <p:cNvGrpSpPr/>
          <p:nvPr/>
        </p:nvGrpSpPr>
        <p:grpSpPr>
          <a:xfrm>
            <a:off x="2140812" y="426129"/>
            <a:ext cx="9505189" cy="5353235"/>
            <a:chOff x="2140812" y="426129"/>
            <a:chExt cx="9505189" cy="535323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AD600F7E-E5D3-4103-B8F9-DD08304771A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11297"/>
            <a:stretch/>
          </p:blipFill>
          <p:spPr>
            <a:xfrm>
              <a:off x="3581400" y="426129"/>
              <a:ext cx="5029200" cy="5353235"/>
            </a:xfrm>
            <a:prstGeom prst="rect">
              <a:avLst/>
            </a:prstGeom>
          </p:spPr>
        </p:pic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33098A16-3C29-4898-85C5-D85786636360}"/>
                </a:ext>
              </a:extLst>
            </p:cNvPr>
            <p:cNvSpPr txBox="1"/>
            <p:nvPr/>
          </p:nvSpPr>
          <p:spPr>
            <a:xfrm>
              <a:off x="4090147" y="556426"/>
              <a:ext cx="2067309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Glycero-3-phosphocholine</a:t>
              </a:r>
              <a:endParaRPr lang="en-US" sz="1200" dirty="0"/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98F49DE2-A2C1-43DF-B373-50C48510DA37}"/>
                </a:ext>
              </a:extLst>
            </p:cNvPr>
            <p:cNvSpPr txBox="1"/>
            <p:nvPr/>
          </p:nvSpPr>
          <p:spPr>
            <a:xfrm>
              <a:off x="3233995" y="851402"/>
              <a:ext cx="216771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7alpha-Hydroxypregnenolone</a:t>
              </a:r>
              <a:endParaRPr lang="en-US" sz="1000" dirty="0"/>
            </a:p>
          </p:txBody>
        </p:sp>
        <p:sp>
          <p:nvSpPr>
            <p:cNvPr id="7" name="TextBox 6">
              <a:extLst>
                <a:ext uri="{FF2B5EF4-FFF2-40B4-BE49-F238E27FC236}">
                  <a16:creationId xmlns:a16="http://schemas.microsoft.com/office/drawing/2014/main" id="{D6BC7E67-1D09-44C5-BF17-D522874EA97B}"/>
                </a:ext>
              </a:extLst>
            </p:cNvPr>
            <p:cNvSpPr txBox="1"/>
            <p:nvPr/>
          </p:nvSpPr>
          <p:spPr>
            <a:xfrm>
              <a:off x="2888476" y="2736780"/>
              <a:ext cx="1098105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PC(20:2/18:0)</a:t>
              </a:r>
            </a:p>
          </p:txBody>
        </p:sp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927A8BEB-E974-490F-B54F-7E28FB52057C}"/>
                </a:ext>
              </a:extLst>
            </p:cNvPr>
            <p:cNvSpPr txBox="1"/>
            <p:nvPr/>
          </p:nvSpPr>
          <p:spPr>
            <a:xfrm>
              <a:off x="3304865" y="1568852"/>
              <a:ext cx="1098105" cy="33855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PE(22:6/18:2)</a:t>
              </a:r>
            </a:p>
            <a:p>
              <a:endParaRPr lang="en-US" sz="400" b="1" dirty="0"/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F51FEFFF-B4CD-4119-8158-B0D8C7576F1F}"/>
                </a:ext>
              </a:extLst>
            </p:cNvPr>
            <p:cNvSpPr txBox="1"/>
            <p:nvPr/>
          </p:nvSpPr>
          <p:spPr>
            <a:xfrm>
              <a:off x="4387730" y="5157241"/>
              <a:ext cx="1013979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Testosterone</a:t>
              </a:r>
              <a:endParaRPr lang="en-US" sz="100" b="1" dirty="0"/>
            </a:p>
          </p:txBody>
        </p:sp>
        <p:sp>
          <p:nvSpPr>
            <p:cNvPr id="10" name="TextBox 9">
              <a:extLst>
                <a:ext uri="{FF2B5EF4-FFF2-40B4-BE49-F238E27FC236}">
                  <a16:creationId xmlns:a16="http://schemas.microsoft.com/office/drawing/2014/main" id="{64B63DA1-835B-4488-BDAC-7967FF77E9E3}"/>
                </a:ext>
              </a:extLst>
            </p:cNvPr>
            <p:cNvSpPr txBox="1"/>
            <p:nvPr/>
          </p:nvSpPr>
          <p:spPr>
            <a:xfrm>
              <a:off x="3012899" y="2147926"/>
              <a:ext cx="1137002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5alpha-THDOC</a:t>
              </a:r>
              <a:endParaRPr lang="en-US" sz="100" b="1" dirty="0"/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E17E60CD-C48B-4CBB-A3F6-F6C0A01C6D03}"/>
                </a:ext>
              </a:extLst>
            </p:cNvPr>
            <p:cNvSpPr txBox="1"/>
            <p:nvPr/>
          </p:nvSpPr>
          <p:spPr>
            <a:xfrm>
              <a:off x="2847692" y="3327946"/>
              <a:ext cx="1137002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 err="1"/>
                <a:t>LysoPA</a:t>
              </a:r>
              <a:r>
                <a:rPr lang="en-US" sz="1200" b="1" dirty="0"/>
                <a:t>(18:2)</a:t>
              </a:r>
            </a:p>
          </p:txBody>
        </p:sp>
        <p:sp>
          <p:nvSpPr>
            <p:cNvPr id="12" name="TextBox 11">
              <a:extLst>
                <a:ext uri="{FF2B5EF4-FFF2-40B4-BE49-F238E27FC236}">
                  <a16:creationId xmlns:a16="http://schemas.microsoft.com/office/drawing/2014/main" id="{34C59DB3-F762-4E8E-9931-C61802DC1AE7}"/>
                </a:ext>
              </a:extLst>
            </p:cNvPr>
            <p:cNvSpPr txBox="1"/>
            <p:nvPr/>
          </p:nvSpPr>
          <p:spPr>
            <a:xfrm>
              <a:off x="3148798" y="4880242"/>
              <a:ext cx="1745921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17-Hydroxylinolenic acid</a:t>
              </a:r>
              <a:endParaRPr lang="en-US" sz="100" b="1" dirty="0"/>
            </a:p>
          </p:txBody>
        </p:sp>
        <p:sp>
          <p:nvSpPr>
            <p:cNvPr id="13" name="TextBox 12">
              <a:extLst>
                <a:ext uri="{FF2B5EF4-FFF2-40B4-BE49-F238E27FC236}">
                  <a16:creationId xmlns:a16="http://schemas.microsoft.com/office/drawing/2014/main" id="{0F373EAB-76FA-4A76-857A-AC78F6BD24A4}"/>
                </a:ext>
              </a:extLst>
            </p:cNvPr>
            <p:cNvSpPr txBox="1"/>
            <p:nvPr/>
          </p:nvSpPr>
          <p:spPr>
            <a:xfrm>
              <a:off x="3233994" y="4464743"/>
              <a:ext cx="1223042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 err="1"/>
                <a:t>Stearidonic</a:t>
              </a:r>
              <a:r>
                <a:rPr lang="en-US" sz="1200" b="1" dirty="0"/>
                <a:t> acid</a:t>
              </a:r>
              <a:endParaRPr lang="en-US" sz="200" b="1" dirty="0"/>
            </a:p>
          </p:txBody>
        </p:sp>
        <p:sp>
          <p:nvSpPr>
            <p:cNvPr id="14" name="TextBox 13">
              <a:extLst>
                <a:ext uri="{FF2B5EF4-FFF2-40B4-BE49-F238E27FC236}">
                  <a16:creationId xmlns:a16="http://schemas.microsoft.com/office/drawing/2014/main" id="{D20C75A4-3D81-4488-99A2-DAB457AA56F0}"/>
                </a:ext>
              </a:extLst>
            </p:cNvPr>
            <p:cNvSpPr txBox="1"/>
            <p:nvPr/>
          </p:nvSpPr>
          <p:spPr>
            <a:xfrm>
              <a:off x="3988214" y="1164413"/>
              <a:ext cx="864094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 err="1"/>
                <a:t>Traumatin</a:t>
              </a:r>
              <a:endParaRPr lang="en-US" sz="100" b="1" dirty="0"/>
            </a:p>
          </p:txBody>
        </p:sp>
        <p:sp>
          <p:nvSpPr>
            <p:cNvPr id="15" name="TextBox 14">
              <a:extLst>
                <a:ext uri="{FF2B5EF4-FFF2-40B4-BE49-F238E27FC236}">
                  <a16:creationId xmlns:a16="http://schemas.microsoft.com/office/drawing/2014/main" id="{85B44F76-B904-419F-8DED-6D189A9AFCE0}"/>
                </a:ext>
              </a:extLst>
            </p:cNvPr>
            <p:cNvSpPr txBox="1"/>
            <p:nvPr/>
          </p:nvSpPr>
          <p:spPr>
            <a:xfrm>
              <a:off x="5660839" y="778998"/>
              <a:ext cx="280796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US" sz="600" dirty="0"/>
            </a:p>
          </p:txBody>
        </p:sp>
        <p:sp>
          <p:nvSpPr>
            <p:cNvPr id="16" name="TextBox 15">
              <a:extLst>
                <a:ext uri="{FF2B5EF4-FFF2-40B4-BE49-F238E27FC236}">
                  <a16:creationId xmlns:a16="http://schemas.microsoft.com/office/drawing/2014/main" id="{1CEF35D4-8518-4E1D-806D-0CC57EB28119}"/>
                </a:ext>
              </a:extLst>
            </p:cNvPr>
            <p:cNvSpPr txBox="1"/>
            <p:nvPr/>
          </p:nvSpPr>
          <p:spPr>
            <a:xfrm>
              <a:off x="2140812" y="3928954"/>
              <a:ext cx="2015972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5alpha-Pregnane-3,20-dione</a:t>
              </a:r>
              <a:endParaRPr lang="en-US" sz="100" b="1" dirty="0"/>
            </a:p>
          </p:txBody>
        </p:sp>
        <p:sp>
          <p:nvSpPr>
            <p:cNvPr id="17" name="TextBox 16">
              <a:extLst>
                <a:ext uri="{FF2B5EF4-FFF2-40B4-BE49-F238E27FC236}">
                  <a16:creationId xmlns:a16="http://schemas.microsoft.com/office/drawing/2014/main" id="{5F9CC6E1-9892-42C0-BA24-AC774AFA923E}"/>
                </a:ext>
              </a:extLst>
            </p:cNvPr>
            <p:cNvSpPr txBox="1"/>
            <p:nvPr/>
          </p:nvSpPr>
          <p:spPr>
            <a:xfrm>
              <a:off x="4688040" y="5434240"/>
              <a:ext cx="1321532" cy="276999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r>
                <a:rPr lang="en-US" sz="1200" b="1" dirty="0"/>
                <a:t>Allopregnanolone</a:t>
              </a:r>
              <a:endParaRPr lang="en-US" sz="100" b="1" dirty="0"/>
            </a:p>
          </p:txBody>
        </p:sp>
        <p:sp>
          <p:nvSpPr>
            <p:cNvPr id="18" name="TextBox 17">
              <a:extLst>
                <a:ext uri="{FF2B5EF4-FFF2-40B4-BE49-F238E27FC236}">
                  <a16:creationId xmlns:a16="http://schemas.microsoft.com/office/drawing/2014/main" id="{D05B857A-45E2-43A1-987C-FDB8470CA37A}"/>
                </a:ext>
              </a:extLst>
            </p:cNvPr>
            <p:cNvSpPr txBox="1"/>
            <p:nvPr/>
          </p:nvSpPr>
          <p:spPr>
            <a:xfrm>
              <a:off x="5693913" y="5295299"/>
              <a:ext cx="280796" cy="184666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endParaRPr lang="en-US" sz="600" dirty="0"/>
            </a:p>
          </p:txBody>
        </p: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A2A2581F-1D4B-4D0D-A615-09B254D92E59}"/>
                </a:ext>
              </a:extLst>
            </p:cNvPr>
            <p:cNvGrpSpPr/>
            <p:nvPr/>
          </p:nvGrpSpPr>
          <p:grpSpPr>
            <a:xfrm>
              <a:off x="8660751" y="2602305"/>
              <a:ext cx="2592514" cy="261610"/>
              <a:chOff x="8910927" y="1753991"/>
              <a:chExt cx="2592514" cy="261610"/>
            </a:xfrm>
          </p:grpSpPr>
          <p:sp>
            <p:nvSpPr>
              <p:cNvPr id="23" name="Rectangle 22">
                <a:extLst>
                  <a:ext uri="{FF2B5EF4-FFF2-40B4-BE49-F238E27FC236}">
                    <a16:creationId xmlns:a16="http://schemas.microsoft.com/office/drawing/2014/main" id="{1E0BDC4A-20D7-4AED-81DB-D908477C1649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377EB8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82E2BC3C-2B08-40CB-AA11-93BA1E75708A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40963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Glycerophospholipid metabolism</a:t>
                </a:r>
              </a:p>
            </p:txBody>
          </p: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F18EEFB6-4A6D-421D-8677-F70CB0E9A2A3}"/>
                </a:ext>
              </a:extLst>
            </p:cNvPr>
            <p:cNvGrpSpPr/>
            <p:nvPr/>
          </p:nvGrpSpPr>
          <p:grpSpPr>
            <a:xfrm>
              <a:off x="8660751" y="2942277"/>
              <a:ext cx="2985250" cy="261610"/>
              <a:chOff x="8910927" y="1753991"/>
              <a:chExt cx="2985250" cy="261610"/>
            </a:xfrm>
          </p:grpSpPr>
          <p:sp>
            <p:nvSpPr>
              <p:cNvPr id="26" name="Rectangle 25">
                <a:extLst>
                  <a:ext uri="{FF2B5EF4-FFF2-40B4-BE49-F238E27FC236}">
                    <a16:creationId xmlns:a16="http://schemas.microsoft.com/office/drawing/2014/main" id="{377D5446-14B8-4D9C-BF82-D54845BD2AE9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4CAF4A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27" name="TextBox 26">
                <a:extLst>
                  <a:ext uri="{FF2B5EF4-FFF2-40B4-BE49-F238E27FC236}">
                    <a16:creationId xmlns:a16="http://schemas.microsoft.com/office/drawing/2014/main" id="{E0DF87B5-3254-4D47-AF6E-7C60C326744E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802370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Retrograde endocannabinoid signaling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28" name="Group 27">
              <a:extLst>
                <a:ext uri="{FF2B5EF4-FFF2-40B4-BE49-F238E27FC236}">
                  <a16:creationId xmlns:a16="http://schemas.microsoft.com/office/drawing/2014/main" id="{06BF956F-11E7-4853-A11A-B1B14DED9385}"/>
                </a:ext>
              </a:extLst>
            </p:cNvPr>
            <p:cNvGrpSpPr/>
            <p:nvPr/>
          </p:nvGrpSpPr>
          <p:grpSpPr>
            <a:xfrm>
              <a:off x="8660751" y="3282249"/>
              <a:ext cx="2866628" cy="261610"/>
              <a:chOff x="8910927" y="1753991"/>
              <a:chExt cx="2866628" cy="261610"/>
            </a:xfrm>
          </p:grpSpPr>
          <p:sp>
            <p:nvSpPr>
              <p:cNvPr id="29" name="Rectangle 28">
                <a:extLst>
                  <a:ext uri="{FF2B5EF4-FFF2-40B4-BE49-F238E27FC236}">
                    <a16:creationId xmlns:a16="http://schemas.microsoft.com/office/drawing/2014/main" id="{3909C2B7-6635-49EA-B157-0571E83997B4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984DA3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0" name="TextBox 29">
                <a:extLst>
                  <a:ext uri="{FF2B5EF4-FFF2-40B4-BE49-F238E27FC236}">
                    <a16:creationId xmlns:a16="http://schemas.microsoft.com/office/drawing/2014/main" id="{46CAE130-0895-471D-9EF3-F1D93E9AC2C3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68374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thogenic Escherichia coli infection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1" name="Group 30">
              <a:extLst>
                <a:ext uri="{FF2B5EF4-FFF2-40B4-BE49-F238E27FC236}">
                  <a16:creationId xmlns:a16="http://schemas.microsoft.com/office/drawing/2014/main" id="{D162C485-B2BD-4378-BF49-AEFDE80B1B06}"/>
                </a:ext>
              </a:extLst>
            </p:cNvPr>
            <p:cNvGrpSpPr/>
            <p:nvPr/>
          </p:nvGrpSpPr>
          <p:grpSpPr>
            <a:xfrm>
              <a:off x="8660751" y="3622221"/>
              <a:ext cx="2380918" cy="261610"/>
              <a:chOff x="8910927" y="1753991"/>
              <a:chExt cx="2380918" cy="261610"/>
            </a:xfrm>
          </p:grpSpPr>
          <p:sp>
            <p:nvSpPr>
              <p:cNvPr id="32" name="Rectangle 31">
                <a:extLst>
                  <a:ext uri="{FF2B5EF4-FFF2-40B4-BE49-F238E27FC236}">
                    <a16:creationId xmlns:a16="http://schemas.microsoft.com/office/drawing/2014/main" id="{4FD0E606-A7BA-4AE6-B9AC-F6143BD00AB8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FFFF32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3" name="TextBox 32">
                <a:extLst>
                  <a:ext uri="{FF2B5EF4-FFF2-40B4-BE49-F238E27FC236}">
                    <a16:creationId xmlns:a16="http://schemas.microsoft.com/office/drawing/2014/main" id="{5E6E27CA-690D-459D-92EB-CE5EECA9D4A8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198038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Steroid hormone biosynthesis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  <p:grpSp>
          <p:nvGrpSpPr>
            <p:cNvPr id="34" name="Group 33">
              <a:extLst>
                <a:ext uri="{FF2B5EF4-FFF2-40B4-BE49-F238E27FC236}">
                  <a16:creationId xmlns:a16="http://schemas.microsoft.com/office/drawing/2014/main" id="{2CBEAA8A-0243-48D3-8232-9000942E5159}"/>
                </a:ext>
              </a:extLst>
            </p:cNvPr>
            <p:cNvGrpSpPr/>
            <p:nvPr/>
          </p:nvGrpSpPr>
          <p:grpSpPr>
            <a:xfrm>
              <a:off x="8660751" y="3962193"/>
              <a:ext cx="2576484" cy="261610"/>
              <a:chOff x="8910927" y="1753991"/>
              <a:chExt cx="2576484" cy="261610"/>
            </a:xfrm>
          </p:grpSpPr>
          <p:sp>
            <p:nvSpPr>
              <p:cNvPr id="35" name="Rectangle 34">
                <a:extLst>
                  <a:ext uri="{FF2B5EF4-FFF2-40B4-BE49-F238E27FC236}">
                    <a16:creationId xmlns:a16="http://schemas.microsoft.com/office/drawing/2014/main" id="{F1E858CF-11E6-443A-8486-8855BF9B9166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EDB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36" name="TextBox 35">
                <a:extLst>
                  <a:ext uri="{FF2B5EF4-FFF2-40B4-BE49-F238E27FC236}">
                    <a16:creationId xmlns:a16="http://schemas.microsoft.com/office/drawing/2014/main" id="{D10AF944-CE28-4DBC-8A0A-6CC4073ECCDC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2393604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100" b="1" dirty="0">
                    <a:latin typeface="HelveticaNeueforSAS" panose="020B0604020202020204" pitchFamily="34" charset="0"/>
                  </a:rPr>
                  <a:t>Alpha-Linolenic acid metabolism</a:t>
                </a:r>
              </a:p>
            </p:txBody>
          </p:sp>
        </p:grpSp>
        <p:grpSp>
          <p:nvGrpSpPr>
            <p:cNvPr id="40" name="Group 39">
              <a:extLst>
                <a:ext uri="{FF2B5EF4-FFF2-40B4-BE49-F238E27FC236}">
                  <a16:creationId xmlns:a16="http://schemas.microsoft.com/office/drawing/2014/main" id="{9CF84156-1CF5-4149-A2D2-CCA6272B3BE7}"/>
                </a:ext>
              </a:extLst>
            </p:cNvPr>
            <p:cNvGrpSpPr/>
            <p:nvPr/>
          </p:nvGrpSpPr>
          <p:grpSpPr>
            <a:xfrm>
              <a:off x="8660751" y="4341632"/>
              <a:ext cx="1598652" cy="261610"/>
              <a:chOff x="8910927" y="1753991"/>
              <a:chExt cx="1598652" cy="261610"/>
            </a:xfrm>
          </p:grpSpPr>
          <p:sp>
            <p:nvSpPr>
              <p:cNvPr id="41" name="Rectangle 40">
                <a:extLst>
                  <a:ext uri="{FF2B5EF4-FFF2-40B4-BE49-F238E27FC236}">
                    <a16:creationId xmlns:a16="http://schemas.microsoft.com/office/drawing/2014/main" id="{E7CEE80C-CD25-47C9-8F39-3BC7D75275D1}"/>
                  </a:ext>
                </a:extLst>
              </p:cNvPr>
              <p:cNvSpPr/>
              <p:nvPr/>
            </p:nvSpPr>
            <p:spPr>
              <a:xfrm>
                <a:off x="8910927" y="1793356"/>
                <a:ext cx="182880" cy="182880"/>
              </a:xfrm>
              <a:prstGeom prst="rect">
                <a:avLst/>
              </a:prstGeom>
              <a:solidFill>
                <a:srgbClr val="A6761C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42" name="TextBox 41">
                <a:extLst>
                  <a:ext uri="{FF2B5EF4-FFF2-40B4-BE49-F238E27FC236}">
                    <a16:creationId xmlns:a16="http://schemas.microsoft.com/office/drawing/2014/main" id="{3D883CB1-CFFE-4972-BB29-CA7E1CFBD66C}"/>
                  </a:ext>
                </a:extLst>
              </p:cNvPr>
              <p:cNvSpPr txBox="1"/>
              <p:nvPr/>
            </p:nvSpPr>
            <p:spPr>
              <a:xfrm>
                <a:off x="9093807" y="1753991"/>
                <a:ext cx="1415772" cy="2616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zh-CN" sz="1100" b="1" dirty="0">
                    <a:latin typeface="HelveticaNeueforSAS" panose="020B0604020202020204" pitchFamily="34" charset="0"/>
                  </a:rPr>
                  <a:t>Pancreatic cancer</a:t>
                </a:r>
                <a:endParaRPr lang="en-US" sz="1100" b="1" dirty="0">
                  <a:latin typeface="HelveticaNeueforSAS" panose="020B0604020202020204" pitchFamily="34" charset="0"/>
                </a:endParaRPr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9508023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794</TotalTime>
  <Words>377</Words>
  <Application>Microsoft Office PowerPoint</Application>
  <PresentationFormat>Widescreen</PresentationFormat>
  <Paragraphs>110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3" baseType="lpstr">
      <vt:lpstr>Arial</vt:lpstr>
      <vt:lpstr>Calibri</vt:lpstr>
      <vt:lpstr>Calibri Light</vt:lpstr>
      <vt:lpstr>等线</vt:lpstr>
      <vt:lpstr>HelveticaNeueforSAS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NA CARPENTER</dc:creator>
  <cp:lastModifiedBy>ALANA CARPENTER</cp:lastModifiedBy>
  <cp:revision>48</cp:revision>
  <dcterms:created xsi:type="dcterms:W3CDTF">2023-11-02T18:02:49Z</dcterms:created>
  <dcterms:modified xsi:type="dcterms:W3CDTF">2023-12-21T16:32:37Z</dcterms:modified>
</cp:coreProperties>
</file>